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5.jpeg" ContentType="image/jpeg"/>
  <Override PartName="/ppt/media/image21.jpeg" ContentType="image/jpeg"/>
  <Override PartName="/ppt/media/image20.jpeg" ContentType="image/jpeg"/>
  <Override PartName="/ppt/media/image19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22.jpeg" ContentType="image/jpeg"/>
  <Override PartName="/ppt/media/image27.jpeg" ContentType="image/jpeg"/>
  <Override PartName="/ppt/media/image6.jpeg" ContentType="image/jpeg"/>
  <Override PartName="/ppt/media/image33.jpeg" ContentType="image/jpeg"/>
  <Override PartName="/ppt/media/image10.jpeg" ContentType="image/jpeg"/>
  <Override PartName="/ppt/media/image29.jpeg" ContentType="image/jpeg"/>
  <Override PartName="/ppt/media/image28.jpeg" ContentType="image/jpeg"/>
  <Override PartName="/ppt/media/image34.jpeg" ContentType="image/jpeg"/>
  <Override PartName="/ppt/media/image11.jpeg" ContentType="image/jpeg"/>
  <Override PartName="/ppt/media/image9.jpeg" ContentType="image/jpeg"/>
  <Override PartName="/ppt/media/image30.jpeg" ContentType="image/jpeg"/>
  <Override PartName="/ppt/media/image24.jpeg" ContentType="image/jpeg"/>
  <Override PartName="/ppt/media/image31.jpeg" ContentType="image/jpeg"/>
  <Override PartName="/ppt/media/image7.jpeg" ContentType="image/jpeg"/>
  <Override PartName="/ppt/media/image38.jpeg" ContentType="image/jpeg"/>
  <Override PartName="/ppt/media/image32.jpeg" ContentType="image/jpeg"/>
  <Override PartName="/ppt/media/image5.jpeg" ContentType="image/jpeg"/>
  <Override PartName="/ppt/media/image26.jpeg" ContentType="image/jpeg"/>
  <Override PartName="/ppt/media/image8.jpeg" ContentType="image/jpeg"/>
  <Override PartName="/ppt/media/image39.jpeg" ContentType="image/jpeg"/>
  <Override PartName="/ppt/media/image13.jpeg" ContentType="image/jpeg"/>
  <Override PartName="/ppt/media/image3.jpeg" ContentType="image/jpeg"/>
  <Override PartName="/ppt/media/image37.jpeg" ContentType="image/jpeg"/>
  <Override PartName="/ppt/media/image12.jpeg" ContentType="image/jpeg"/>
  <Override PartName="/ppt/media/image4.png" ContentType="image/png"/>
  <Override PartName="/ppt/media/image36.jpeg" ContentType="image/jpeg"/>
  <Override PartName="/ppt/media/image2.jpeg" ContentType="image/jpeg"/>
  <Override PartName="/ppt/media/image23.jpeg" ContentType="image/jpeg"/>
  <Override PartName="/ppt/media/image35.jpeg" ContentType="image/jpeg"/>
  <Override PartName="/ppt/media/image1.jpeg" ContentType="image/jpeg"/>
  <Override PartName="/ppt/presProps.xml" ContentType="application/vnd.openxmlformats-officedocument.presentationml.presPro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3FA25-D800-498E-A891-6B2366EBBD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8B6D5-F06D-41C7-A53D-CB10B419B4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203DF0-403D-423E-B12F-16AC41423E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03DF8-E9D2-4F2D-9728-47CB6B83FA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CE158E-123B-4E6A-A5D4-8C81B53BA3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4CB74-55BD-4C35-AD4B-8098F747C8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63CB4-FFC9-4C71-B9BB-70812493E8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72D35B-A6BD-44B4-9183-C6EC03B820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81322C-5DD8-47BD-BF3A-5812132F37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8CDD8-8F17-4ABC-B206-1579777BCA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45293A-4ED5-4AE6-9731-FBB8366805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14A43-776C-4B46-9691-BDF473931F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50EBFC-BF5D-43AB-AD4F-B1F283ED462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30.jpe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1.jpeg"/><Relationship Id="rId2" Type="http://schemas.openxmlformats.org/officeDocument/2006/relationships/image" Target="../media/image32.jpeg"/><Relationship Id="rId3" Type="http://schemas.openxmlformats.org/officeDocument/2006/relationships/image" Target="../media/image33.jpe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4.jpeg"/><Relationship Id="rId2" Type="http://schemas.openxmlformats.org/officeDocument/2006/relationships/image" Target="../media/image35.jpeg"/><Relationship Id="rId3" Type="http://schemas.openxmlformats.org/officeDocument/2006/relationships/image" Target="../media/image4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36.jpeg"/><Relationship Id="rId2" Type="http://schemas.openxmlformats.org/officeDocument/2006/relationships/image" Target="../media/image37.jpeg"/><Relationship Id="rId3" Type="http://schemas.openxmlformats.org/officeDocument/2006/relationships/image" Target="../media/image4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38.jpeg"/><Relationship Id="rId2" Type="http://schemas.openxmlformats.org/officeDocument/2006/relationships/image" Target="../media/image39.jpeg"/><Relationship Id="rId3" Type="http://schemas.openxmlformats.org/officeDocument/2006/relationships/image" Target="../media/image4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image" Target="../media/image17.jpe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8.jpeg"/><Relationship Id="rId2" Type="http://schemas.openxmlformats.org/officeDocument/2006/relationships/image" Target="../media/image19.jpeg"/><Relationship Id="rId3" Type="http://schemas.openxmlformats.org/officeDocument/2006/relationships/image" Target="../media/image20.jpeg"/><Relationship Id="rId4" Type="http://schemas.openxmlformats.org/officeDocument/2006/relationships/image" Target="../media/image21.jpe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2.jpeg"/><Relationship Id="rId2" Type="http://schemas.openxmlformats.org/officeDocument/2006/relationships/image" Target="../media/image23.jpeg"/><Relationship Id="rId3" Type="http://schemas.openxmlformats.org/officeDocument/2006/relationships/image" Target="../media/image24.jpe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5.jpeg"/><Relationship Id="rId2" Type="http://schemas.openxmlformats.org/officeDocument/2006/relationships/image" Target="../media/image26.jpe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7.jpeg"/><Relationship Id="rId2" Type="http://schemas.openxmlformats.org/officeDocument/2006/relationships/image" Target="../media/image28.jpeg"/><Relationship Id="rId3" Type="http://schemas.openxmlformats.org/officeDocument/2006/relationships/image" Target="../media/image29.jpeg"/><Relationship Id="rId4" Type="http://schemas.openxmlformats.org/officeDocument/2006/relationships/image" Target="../media/image4.pn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36520" y="5394240"/>
            <a:ext cx="6583320" cy="27068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705200" y="7558200"/>
            <a:ext cx="584280" cy="0"/>
          </a:xfrm>
          <a:prstGeom prst="line">
            <a:avLst/>
          </a:prstGeom>
          <a:ln w="381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297400" y="7559640"/>
            <a:ext cx="1096920" cy="0"/>
          </a:xfrm>
          <a:prstGeom prst="line">
            <a:avLst/>
          </a:prstGeom>
          <a:ln w="381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flipH="1" rot="10800000">
            <a:off x="5254560" y="7584840"/>
            <a:ext cx="76320" cy="169560"/>
          </a:xfrm>
          <a:prstGeom prst="flowChartMerge">
            <a:avLst/>
          </a:prstGeom>
          <a:solidFill>
            <a:srgbClr val="ff00ff"/>
          </a:solidFill>
          <a:ln w="9360">
            <a:solidFill>
              <a:srgbClr val="cc00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676480" y="75024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878000" y="75024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e2b7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"/>
          <p:cNvGrpSpPr/>
          <p:nvPr/>
        </p:nvGrpSpPr>
        <p:grpSpPr>
          <a:xfrm>
            <a:off x="228600" y="219240"/>
            <a:ext cx="6400800" cy="2647800"/>
            <a:chOff x="228600" y="219240"/>
            <a:chExt cx="6400800" cy="2647800"/>
          </a:xfrm>
        </p:grpSpPr>
        <p:pic>
          <p:nvPicPr>
            <p:cNvPr id="48" name="" descr=""/>
            <p:cNvPicPr/>
            <p:nvPr/>
          </p:nvPicPr>
          <p:blipFill>
            <a:blip r:embed="rId2"/>
            <a:stretch/>
          </p:blipFill>
          <p:spPr>
            <a:xfrm>
              <a:off x="228600" y="219240"/>
              <a:ext cx="6400800" cy="2647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"/>
            <p:cNvSpPr/>
            <p:nvPr/>
          </p:nvSpPr>
          <p:spPr>
            <a:xfrm>
              <a:off x="525600" y="2467080"/>
              <a:ext cx="698400" cy="0"/>
            </a:xfrm>
            <a:prstGeom prst="line">
              <a:avLst/>
            </a:prstGeom>
            <a:ln w="38160">
              <a:solidFill>
                <a:srgbClr val="3333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244520" y="2467080"/>
              <a:ext cx="432000" cy="0"/>
            </a:xfrm>
            <a:prstGeom prst="line">
              <a:avLst/>
            </a:prstGeom>
            <a:ln w="38160">
              <a:solidFill>
                <a:srgbClr val="fd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128680" y="2467080"/>
              <a:ext cx="2590920" cy="0"/>
            </a:xfrm>
            <a:prstGeom prst="line">
              <a:avLst/>
            </a:prstGeom>
            <a:ln w="38160">
              <a:solidFill>
                <a:srgbClr val="fd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734000" y="2467080"/>
              <a:ext cx="520560" cy="0"/>
            </a:xfrm>
            <a:prstGeom prst="line">
              <a:avLst/>
            </a:prstGeom>
            <a:ln w="381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H="1" rot="10800000">
              <a:off x="1193760" y="2498760"/>
              <a:ext cx="76320" cy="169920"/>
            </a:xfrm>
            <a:prstGeom prst="flowChartMerge">
              <a:avLst/>
            </a:prstGeom>
            <a:solidFill>
              <a:srgbClr val="ff3399"/>
            </a:solidFill>
            <a:ln w="9360">
              <a:solidFill>
                <a:srgbClr val="d6009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160" bIns="381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H="1" rot="10800000">
              <a:off x="4685400" y="2495520"/>
              <a:ext cx="75960" cy="169920"/>
            </a:xfrm>
            <a:prstGeom prst="flowChartMerge">
              <a:avLst/>
            </a:prstGeom>
            <a:solidFill>
              <a:srgbClr val="ff3399"/>
            </a:solidFill>
            <a:ln w="9360">
              <a:solidFill>
                <a:srgbClr val="d6009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160" bIns="381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86160" y="241920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33ff"/>
                  </a:solidFill>
                  <a:latin typeface="Arial"/>
                </a:rPr>
                <a:t>2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267200" y="241920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d0101"/>
                  </a:solidFill>
                  <a:latin typeface="Arial"/>
                </a:rPr>
                <a:t>1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376800" y="242568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d0101"/>
                  </a:solidFill>
                  <a:latin typeface="Arial"/>
                </a:rPr>
                <a:t>1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801680" y="242892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e2b700"/>
                  </a:solidFill>
                  <a:latin typeface="Arial"/>
                </a:rPr>
                <a:t>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727280" y="324000"/>
              <a:ext cx="338724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uman chromosome 1 – difference NLE24&amp;9-NLE9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"/>
          <p:cNvGrpSpPr/>
          <p:nvPr/>
        </p:nvGrpSpPr>
        <p:grpSpPr>
          <a:xfrm>
            <a:off x="152280" y="2819520"/>
            <a:ext cx="6489720" cy="2631960"/>
            <a:chOff x="152280" y="2819520"/>
            <a:chExt cx="6489720" cy="2631960"/>
          </a:xfrm>
        </p:grpSpPr>
        <p:pic>
          <p:nvPicPr>
            <p:cNvPr id="61" name="" descr=""/>
            <p:cNvPicPr/>
            <p:nvPr/>
          </p:nvPicPr>
          <p:blipFill>
            <a:blip r:embed="rId3"/>
            <a:stretch/>
          </p:blipFill>
          <p:spPr>
            <a:xfrm>
              <a:off x="152280" y="2819520"/>
              <a:ext cx="6489720" cy="263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"/>
            <p:cNvSpPr/>
            <p:nvPr/>
          </p:nvSpPr>
          <p:spPr>
            <a:xfrm>
              <a:off x="1198440" y="5019840"/>
              <a:ext cx="533520" cy="0"/>
            </a:xfrm>
            <a:prstGeom prst="line">
              <a:avLst/>
            </a:prstGeom>
            <a:ln w="38160">
              <a:solidFill>
                <a:srgbClr val="fd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739880" y="5019840"/>
              <a:ext cx="347760" cy="0"/>
            </a:xfrm>
            <a:prstGeom prst="line">
              <a:avLst/>
            </a:prstGeom>
            <a:ln w="381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092320" y="5019840"/>
              <a:ext cx="2631960" cy="0"/>
            </a:xfrm>
            <a:prstGeom prst="line">
              <a:avLst/>
            </a:prstGeom>
            <a:ln w="38160">
              <a:solidFill>
                <a:srgbClr val="fd010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H="1" rot="10800000">
              <a:off x="1698480" y="5045040"/>
              <a:ext cx="76320" cy="169920"/>
            </a:xfrm>
            <a:prstGeom prst="flowChartMerge">
              <a:avLst/>
            </a:prstGeom>
            <a:solidFill>
              <a:srgbClr val="ff00ff"/>
            </a:solidFill>
            <a:ln w="9360">
              <a:solidFill>
                <a:srgbClr val="cc00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160" bIns="381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H="1" rot="10800000">
              <a:off x="2054160" y="5045040"/>
              <a:ext cx="76320" cy="169920"/>
            </a:xfrm>
            <a:prstGeom prst="flowChartMerge">
              <a:avLst/>
            </a:prstGeom>
            <a:solidFill>
              <a:srgbClr val="ff00ff"/>
            </a:solidFill>
            <a:ln w="9360">
              <a:solidFill>
                <a:srgbClr val="cc00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160" bIns="381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153240" y="497664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d0101"/>
                  </a:solidFill>
                  <a:latin typeface="Arial"/>
                </a:rPr>
                <a:t>1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262520" y="497664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d0101"/>
                  </a:solidFill>
                  <a:latin typeface="Arial"/>
                </a:rPr>
                <a:t>1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766520" y="498168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cc33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751040" y="2989440"/>
              <a:ext cx="322560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uman chromosome 1 – difference NLE5-NLE12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" name=""/>
          <p:cNvSpPr/>
          <p:nvPr/>
        </p:nvSpPr>
        <p:spPr>
          <a:xfrm>
            <a:off x="1792440" y="5584680"/>
            <a:ext cx="33872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1 – difference NLE24&amp;9-NLE5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"/>
          <p:cNvGrpSpPr/>
          <p:nvPr/>
        </p:nvGrpSpPr>
        <p:grpSpPr>
          <a:xfrm>
            <a:off x="1001880" y="8284680"/>
            <a:ext cx="4934880" cy="196920"/>
            <a:chOff x="1001880" y="8284680"/>
            <a:chExt cx="4934880" cy="196920"/>
          </a:xfrm>
        </p:grpSpPr>
        <p:sp>
          <p:nvSpPr>
            <p:cNvPr id="73" name=""/>
            <p:cNvSpPr/>
            <p:nvPr/>
          </p:nvSpPr>
          <p:spPr>
            <a:xfrm rot="16200000">
              <a:off x="2064240" y="7222320"/>
              <a:ext cx="196920" cy="232164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08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rot="16200000">
              <a:off x="4572720" y="7117560"/>
              <a:ext cx="196920" cy="253116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08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rot="16200000">
              <a:off x="1084680" y="8346960"/>
              <a:ext cx="196920" cy="723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rot="16200000">
              <a:off x="1398600" y="8310600"/>
              <a:ext cx="196920" cy="1450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 rot="16200000">
              <a:off x="1580760" y="8334720"/>
              <a:ext cx="196920" cy="957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 rot="16200000">
              <a:off x="1749960" y="8334000"/>
              <a:ext cx="196920" cy="9720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rot="16200000">
              <a:off x="2318760" y="8129520"/>
              <a:ext cx="196920" cy="5072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rot="16200000">
              <a:off x="2911320" y="8237520"/>
              <a:ext cx="196920" cy="2912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rot="16200000">
              <a:off x="3188520" y="8346960"/>
              <a:ext cx="196920" cy="723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 rot="16200000">
              <a:off x="3915000" y="8334000"/>
              <a:ext cx="196920" cy="9720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 rot="16200000">
              <a:off x="4181040" y="8334000"/>
              <a:ext cx="196920" cy="9720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rot="16200000">
              <a:off x="4664520" y="8092080"/>
              <a:ext cx="196920" cy="5821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16200000">
              <a:off x="5342400" y="8274240"/>
              <a:ext cx="196920" cy="21780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 rot="16200000">
              <a:off x="5668560" y="8334000"/>
              <a:ext cx="196920" cy="9720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 rot="16200000">
              <a:off x="3448800" y="8242920"/>
              <a:ext cx="196920" cy="27972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50000">
                  <a:srgbClr val="b2b2b2"/>
                </a:gs>
                <a:gs pos="100000">
                  <a:srgbClr val="000000"/>
                </a:gs>
              </a:gsLst>
              <a:lin ang="10800000"/>
            </a:gradFill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6200000">
              <a:off x="3289680" y="8345880"/>
              <a:ext cx="142200" cy="7920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2400" bIns="32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"/>
          <p:cNvSpPr/>
          <p:nvPr/>
        </p:nvSpPr>
        <p:spPr>
          <a:xfrm>
            <a:off x="1001880" y="8204040"/>
            <a:ext cx="460080" cy="1800"/>
          </a:xfrm>
          <a:prstGeom prst="line">
            <a:avLst/>
          </a:prstGeom>
          <a:ln w="38160">
            <a:solidFill>
              <a:srgbClr val="33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484280" y="8204040"/>
            <a:ext cx="460440" cy="1800"/>
          </a:xfrm>
          <a:prstGeom prst="line">
            <a:avLst/>
          </a:prstGeom>
          <a:ln w="38160">
            <a:solidFill>
              <a:srgbClr val="fd010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967040" y="8204040"/>
            <a:ext cx="312480" cy="1800"/>
          </a:xfrm>
          <a:prstGeom prst="line">
            <a:avLst/>
          </a:prstGeom>
          <a:ln w="381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292480" y="8204040"/>
            <a:ext cx="2171520" cy="1800"/>
          </a:xfrm>
          <a:prstGeom prst="line">
            <a:avLst/>
          </a:prstGeom>
          <a:ln w="38160">
            <a:solidFill>
              <a:srgbClr val="fd010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489560" y="8204040"/>
            <a:ext cx="609480" cy="1800"/>
          </a:xfrm>
          <a:prstGeom prst="line">
            <a:avLst/>
          </a:prstGeom>
          <a:ln w="381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124600" y="8204040"/>
            <a:ext cx="812520" cy="1800"/>
          </a:xfrm>
          <a:prstGeom prst="line">
            <a:avLst/>
          </a:prstGeom>
          <a:ln w="381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060920" y="79754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33ff"/>
                </a:solidFill>
                <a:latin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441800" y="79754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d0101"/>
                </a:solidFill>
                <a:latin typeface="Arial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270600" y="79754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d0101"/>
                </a:solidFill>
                <a:latin typeface="Arial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976040" y="7980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365080" y="79754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630320" y="7980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e2b7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397600" y="8456760"/>
            <a:ext cx="20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6" name="" descr=""/>
          <p:cNvPicPr/>
          <p:nvPr/>
        </p:nvPicPr>
        <p:blipFill>
          <a:blip r:embed="rId1"/>
          <a:stretch/>
        </p:blipFill>
        <p:spPr>
          <a:xfrm>
            <a:off x="304920" y="406440"/>
            <a:ext cx="6172200" cy="3048120"/>
          </a:xfrm>
          <a:prstGeom prst="rect">
            <a:avLst/>
          </a:prstGeom>
          <a:ln w="0">
            <a:noFill/>
          </a:ln>
        </p:spPr>
      </p:pic>
      <p:sp>
        <p:nvSpPr>
          <p:cNvPr id="557" name=""/>
          <p:cNvSpPr/>
          <p:nvPr/>
        </p:nvSpPr>
        <p:spPr>
          <a:xfrm>
            <a:off x="647640" y="2990880"/>
            <a:ext cx="2171880" cy="0"/>
          </a:xfrm>
          <a:prstGeom prst="line">
            <a:avLst/>
          </a:prstGeom>
          <a:ln w="381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3695760" y="2984400"/>
            <a:ext cx="2628720" cy="0"/>
          </a:xfrm>
          <a:prstGeom prst="line">
            <a:avLst/>
          </a:prstGeom>
          <a:ln w="381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2971800" y="2984400"/>
            <a:ext cx="698400" cy="0"/>
          </a:xfrm>
          <a:prstGeom prst="line">
            <a:avLst/>
          </a:prstGeom>
          <a:ln w="381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3505320" y="1219320"/>
            <a:ext cx="152280" cy="75960"/>
          </a:xfrm>
          <a:prstGeom prst="rect">
            <a:avLst/>
          </a:prstGeom>
          <a:solidFill>
            <a:srgbClr val="35f735"/>
          </a:solidFill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4660920" y="635040"/>
            <a:ext cx="152280" cy="76320"/>
          </a:xfrm>
          <a:prstGeom prst="rect">
            <a:avLst/>
          </a:prstGeom>
          <a:solidFill>
            <a:srgbClr val="35f735"/>
          </a:solidFill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4765320" y="542880"/>
            <a:ext cx="153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egmental duplic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 flipH="1" rot="10800000">
            <a:off x="2781360" y="3035160"/>
            <a:ext cx="76320" cy="169920"/>
          </a:xfrm>
          <a:prstGeom prst="flowChartMerge">
            <a:avLst/>
          </a:prstGeom>
          <a:solidFill>
            <a:srgbClr val="57d2ef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 flipH="1" rot="10800000">
            <a:off x="3643920" y="3009960"/>
            <a:ext cx="75960" cy="169920"/>
          </a:xfrm>
          <a:prstGeom prst="flowChartMerge">
            <a:avLst/>
          </a:prstGeom>
          <a:solidFill>
            <a:srgbClr val="c0c0c0"/>
          </a:solidFill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1524240" y="29448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9999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1830600" y="304920"/>
            <a:ext cx="312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1 – difference NLE15-NLE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4829400" y="29448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9999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3161880" y="2946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200a7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9" name=""/>
          <p:cNvGrpSpPr/>
          <p:nvPr/>
        </p:nvGrpSpPr>
        <p:grpSpPr>
          <a:xfrm>
            <a:off x="1905120" y="3704760"/>
            <a:ext cx="2908080" cy="201240"/>
            <a:chOff x="1905120" y="3704760"/>
            <a:chExt cx="2908080" cy="201240"/>
          </a:xfrm>
        </p:grpSpPr>
        <p:sp>
          <p:nvSpPr>
            <p:cNvPr id="570" name=""/>
            <p:cNvSpPr/>
            <p:nvPr/>
          </p:nvSpPr>
          <p:spPr>
            <a:xfrm rot="16200000">
              <a:off x="2320200" y="3289320"/>
              <a:ext cx="201240" cy="103176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 rot="16200000">
              <a:off x="3825720" y="2918520"/>
              <a:ext cx="201240" cy="177336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 rot="16200000">
              <a:off x="2266920" y="3678840"/>
              <a:ext cx="201240" cy="2527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 rot="16200000">
              <a:off x="2550240" y="3746520"/>
              <a:ext cx="201240" cy="1173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 rot="16200000">
              <a:off x="3035160" y="3709080"/>
              <a:ext cx="201240" cy="1922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 rot="16200000">
              <a:off x="3545640" y="3672000"/>
              <a:ext cx="201240" cy="26640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 rot="16200000">
              <a:off x="3904560" y="3672000"/>
              <a:ext cx="201240" cy="2667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 rot="16200000">
              <a:off x="4497480" y="3745800"/>
              <a:ext cx="201240" cy="1191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 rot="16200000">
              <a:off x="2911320" y="3765960"/>
              <a:ext cx="147600" cy="9036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9" name=""/>
          <p:cNvSpPr/>
          <p:nvPr/>
        </p:nvSpPr>
        <p:spPr>
          <a:xfrm>
            <a:off x="1893960" y="3629160"/>
            <a:ext cx="1077840" cy="0"/>
          </a:xfrm>
          <a:prstGeom prst="line">
            <a:avLst/>
          </a:prstGeom>
          <a:ln w="381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>
            <a:off x="3433680" y="3629160"/>
            <a:ext cx="1387440" cy="0"/>
          </a:xfrm>
          <a:prstGeom prst="line">
            <a:avLst/>
          </a:prstGeom>
          <a:ln w="381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2979720" y="3629160"/>
            <a:ext cx="442800" cy="0"/>
          </a:xfrm>
          <a:prstGeom prst="line">
            <a:avLst/>
          </a:prstGeom>
          <a:ln w="381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2333880" y="34020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9999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3839040" y="34005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9999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3030120" y="3402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200a7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2298960" y="3862440"/>
            <a:ext cx="21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6" name="" descr=""/>
          <p:cNvPicPr/>
          <p:nvPr/>
        </p:nvPicPr>
        <p:blipFill>
          <a:blip r:embed="rId1"/>
          <a:stretch/>
        </p:blipFill>
        <p:spPr>
          <a:xfrm>
            <a:off x="279360" y="152280"/>
            <a:ext cx="6172200" cy="2438640"/>
          </a:xfrm>
          <a:prstGeom prst="rect">
            <a:avLst/>
          </a:prstGeom>
          <a:ln w="0">
            <a:noFill/>
          </a:ln>
        </p:spPr>
      </p:pic>
      <p:pic>
        <p:nvPicPr>
          <p:cNvPr id="587" name="" descr=""/>
          <p:cNvPicPr/>
          <p:nvPr/>
        </p:nvPicPr>
        <p:blipFill>
          <a:blip r:embed="rId2"/>
          <a:stretch/>
        </p:blipFill>
        <p:spPr>
          <a:xfrm>
            <a:off x="291960" y="2717640"/>
            <a:ext cx="6172200" cy="2362320"/>
          </a:xfrm>
          <a:prstGeom prst="rect">
            <a:avLst/>
          </a:prstGeom>
          <a:ln w="0">
            <a:noFill/>
          </a:ln>
        </p:spPr>
      </p:pic>
      <p:pic>
        <p:nvPicPr>
          <p:cNvPr id="588" name="" descr=""/>
          <p:cNvPicPr/>
          <p:nvPr/>
        </p:nvPicPr>
        <p:blipFill>
          <a:blip r:embed="rId3"/>
          <a:stretch/>
        </p:blipFill>
        <p:spPr>
          <a:xfrm>
            <a:off x="254160" y="5359320"/>
            <a:ext cx="6146640" cy="2210040"/>
          </a:xfrm>
          <a:prstGeom prst="rect">
            <a:avLst/>
          </a:prstGeom>
          <a:ln w="0">
            <a:noFill/>
          </a:ln>
        </p:spPr>
      </p:pic>
      <p:sp>
        <p:nvSpPr>
          <p:cNvPr id="589" name=""/>
          <p:cNvSpPr/>
          <p:nvPr/>
        </p:nvSpPr>
        <p:spPr>
          <a:xfrm>
            <a:off x="507960" y="2295360"/>
            <a:ext cx="1625760" cy="0"/>
          </a:xfrm>
          <a:prstGeom prst="line">
            <a:avLst/>
          </a:prstGeom>
          <a:ln w="381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>
            <a:off x="2152800" y="2295360"/>
            <a:ext cx="30456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2743200" y="2295360"/>
            <a:ext cx="60948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>
            <a:off x="2038320" y="4775040"/>
            <a:ext cx="41904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2743200" y="4775040"/>
            <a:ext cx="60948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2476440" y="4775040"/>
            <a:ext cx="24768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2743200" y="7245360"/>
            <a:ext cx="52380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2057400" y="7245360"/>
            <a:ext cx="41904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3286080" y="7245360"/>
            <a:ext cx="3038400" cy="0"/>
          </a:xfrm>
          <a:prstGeom prst="line">
            <a:avLst/>
          </a:prstGeom>
          <a:ln w="38160">
            <a:solidFill>
              <a:srgbClr val="99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 flipH="1" rot="10800000">
            <a:off x="2108160" y="2320920"/>
            <a:ext cx="76320" cy="169920"/>
          </a:xfrm>
          <a:prstGeom prst="flowChartMerge">
            <a:avLst/>
          </a:prstGeom>
          <a:solidFill>
            <a:srgbClr val="f84e6a"/>
          </a:solidFill>
          <a:ln w="9360">
            <a:solidFill>
              <a:srgbClr val="f84e6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 flipH="1" rot="10800000">
            <a:off x="2425680" y="4800600"/>
            <a:ext cx="76320" cy="169920"/>
          </a:xfrm>
          <a:prstGeom prst="flowChartMerge">
            <a:avLst/>
          </a:prstGeom>
          <a:solidFill>
            <a:srgbClr val="f84e6a"/>
          </a:solidFill>
          <a:ln w="9360">
            <a:solidFill>
              <a:srgbClr val="f84e6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 flipH="1" rot="10800000">
            <a:off x="2705040" y="4788000"/>
            <a:ext cx="76320" cy="169920"/>
          </a:xfrm>
          <a:prstGeom prst="flowChartMerge">
            <a:avLst/>
          </a:prstGeom>
          <a:solidFill>
            <a:srgbClr val="f84e6a"/>
          </a:solidFill>
          <a:ln w="9360">
            <a:solidFill>
              <a:srgbClr val="f84e6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 flipH="1" rot="10800000">
            <a:off x="3238560" y="7257960"/>
            <a:ext cx="76320" cy="169920"/>
          </a:xfrm>
          <a:prstGeom prst="flowChartMerge">
            <a:avLst/>
          </a:prstGeom>
          <a:solidFill>
            <a:srgbClr val="f84e6a"/>
          </a:solidFill>
          <a:ln w="9360">
            <a:solidFill>
              <a:srgbClr val="f84e6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991080" y="22496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bbe0e3"/>
                </a:solidFill>
                <a:latin typeface="Arial"/>
              </a:rPr>
              <a:t>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2743560" y="22496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>
            <a:off x="2045160" y="47451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2845080" y="47451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2076840" y="7221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>
            <a:off x="2838960" y="7221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2484000" y="47451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4524840" y="72010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0099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1795680" y="73080"/>
            <a:ext cx="315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2– difference NLE23-NLE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>
            <a:off x="1865520" y="2664000"/>
            <a:ext cx="308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2– difference NLE11-NLE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1754280" y="5207040"/>
            <a:ext cx="315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2– difference NLE10-NLE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>
            <a:off x="1905120" y="8023320"/>
            <a:ext cx="782640" cy="0"/>
          </a:xfrm>
          <a:prstGeom prst="line">
            <a:avLst/>
          </a:prstGeom>
          <a:ln w="381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2697120" y="8021520"/>
            <a:ext cx="23508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>
            <a:off x="2943360" y="8021520"/>
            <a:ext cx="16020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"/>
          <p:cNvSpPr/>
          <p:nvPr/>
        </p:nvSpPr>
        <p:spPr>
          <a:xfrm>
            <a:off x="3111480" y="8021520"/>
            <a:ext cx="16200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"/>
          <p:cNvSpPr/>
          <p:nvPr/>
        </p:nvSpPr>
        <p:spPr>
          <a:xfrm>
            <a:off x="3286080" y="8021520"/>
            <a:ext cx="1476360" cy="0"/>
          </a:xfrm>
          <a:prstGeom prst="line">
            <a:avLst/>
          </a:prstGeom>
          <a:ln w="38160">
            <a:solidFill>
              <a:srgbClr val="99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"/>
          <p:cNvSpPr/>
          <p:nvPr/>
        </p:nvSpPr>
        <p:spPr>
          <a:xfrm rot="16200000">
            <a:off x="2144520" y="7867440"/>
            <a:ext cx="200160" cy="663480"/>
          </a:xfrm>
          <a:prstGeom prst="rect">
            <a:avLst/>
          </a:prstGeom>
          <a:gradFill rotWithShape="0">
            <a:gsLst>
              <a:gs pos="0">
                <a:srgbClr val="d9e7fb"/>
              </a:gs>
              <a:gs pos="50000">
                <a:srgbClr val="ffffff"/>
              </a:gs>
              <a:gs pos="100000">
                <a:srgbClr val="d9e7fb"/>
              </a:gs>
            </a:gsLst>
            <a:lin ang="16200000"/>
          </a:gradFill>
          <a:ln w="93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"/>
          <p:cNvSpPr/>
          <p:nvPr/>
        </p:nvSpPr>
        <p:spPr>
          <a:xfrm rot="16200000">
            <a:off x="3620160" y="7166520"/>
            <a:ext cx="200160" cy="2065320"/>
          </a:xfrm>
          <a:prstGeom prst="rect">
            <a:avLst/>
          </a:prstGeom>
          <a:gradFill rotWithShape="0">
            <a:gsLst>
              <a:gs pos="0">
                <a:srgbClr val="d9e7fb"/>
              </a:gs>
              <a:gs pos="50000">
                <a:srgbClr val="ffffff"/>
              </a:gs>
              <a:gs pos="100000">
                <a:srgbClr val="d9e7fb"/>
              </a:gs>
            </a:gsLst>
            <a:lin ang="16200000"/>
          </a:gradFill>
          <a:ln w="93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 rot="16200000">
            <a:off x="2170800" y="8088840"/>
            <a:ext cx="200160" cy="22068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 rot="16200000">
            <a:off x="2674800" y="8111880"/>
            <a:ext cx="200160" cy="17460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 rot="16200000">
            <a:off x="3146040" y="8103960"/>
            <a:ext cx="200160" cy="19044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 rot="16200000">
            <a:off x="3643200" y="7957440"/>
            <a:ext cx="198360" cy="47160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 rot="16200000">
            <a:off x="4093200" y="8103240"/>
            <a:ext cx="200160" cy="19224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 rot="16200000">
            <a:off x="4440960" y="8161920"/>
            <a:ext cx="200160" cy="7488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080" bIns="28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 rot="16200000">
            <a:off x="2562120" y="8153280"/>
            <a:ext cx="144720" cy="9072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920" bIns="439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2124360" y="7791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bbe0e3"/>
                </a:solidFill>
                <a:latin typeface="Arial"/>
              </a:rPr>
              <a:t>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>
            <a:off x="2629440" y="78026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3010320" y="78008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2876040" y="77929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>
            <a:off x="3705480" y="78026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0099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2222640" y="8256600"/>
            <a:ext cx="21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3" name="" descr=""/>
          <p:cNvPicPr/>
          <p:nvPr/>
        </p:nvPicPr>
        <p:blipFill>
          <a:blip r:embed="rId1"/>
          <a:stretch/>
        </p:blipFill>
        <p:spPr>
          <a:xfrm>
            <a:off x="152280" y="257040"/>
            <a:ext cx="6477120" cy="3087720"/>
          </a:xfrm>
          <a:prstGeom prst="rect">
            <a:avLst/>
          </a:prstGeom>
          <a:ln w="0">
            <a:noFill/>
          </a:ln>
        </p:spPr>
      </p:pic>
      <p:sp>
        <p:nvSpPr>
          <p:cNvPr id="634" name=""/>
          <p:cNvSpPr/>
          <p:nvPr/>
        </p:nvSpPr>
        <p:spPr>
          <a:xfrm>
            <a:off x="1270080" y="3000240"/>
            <a:ext cx="458640" cy="0"/>
          </a:xfrm>
          <a:prstGeom prst="line">
            <a:avLst/>
          </a:prstGeom>
          <a:ln w="381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2463840" y="3000240"/>
            <a:ext cx="3975120" cy="0"/>
          </a:xfrm>
          <a:prstGeom prst="line">
            <a:avLst/>
          </a:prstGeom>
          <a:ln w="38160">
            <a:solidFill>
              <a:srgbClr val="33cc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1752480" y="3000240"/>
            <a:ext cx="685800" cy="0"/>
          </a:xfrm>
          <a:prstGeom prst="line">
            <a:avLst/>
          </a:prstGeom>
          <a:ln w="381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 flipH="1" rot="10800000">
            <a:off x="1701720" y="3025800"/>
            <a:ext cx="76320" cy="169920"/>
          </a:xfrm>
          <a:prstGeom prst="flowChartMerge">
            <a:avLst/>
          </a:prstGeom>
          <a:solidFill>
            <a:srgbClr val="f84e6a"/>
          </a:solidFill>
          <a:ln w="9360">
            <a:solidFill>
              <a:srgbClr val="f84e6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 flipH="1" rot="10800000">
            <a:off x="2412000" y="3021120"/>
            <a:ext cx="75960" cy="169920"/>
          </a:xfrm>
          <a:prstGeom prst="flowChartMerge">
            <a:avLst/>
          </a:prstGeom>
          <a:solidFill>
            <a:srgbClr val="f84e6a"/>
          </a:solidFill>
          <a:ln w="9360">
            <a:solidFill>
              <a:srgbClr val="f84e6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1360080" y="29671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>
            <a:off x="3237840" y="29671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>
            <a:off x="1790280" y="29671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cc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2" name="" descr=""/>
          <p:cNvPicPr/>
          <p:nvPr/>
        </p:nvPicPr>
        <p:blipFill>
          <a:blip r:embed="rId2"/>
          <a:stretch/>
        </p:blipFill>
        <p:spPr>
          <a:xfrm>
            <a:off x="127080" y="4448160"/>
            <a:ext cx="6426000" cy="2971800"/>
          </a:xfrm>
          <a:prstGeom prst="rect">
            <a:avLst/>
          </a:prstGeom>
          <a:ln w="0">
            <a:noFill/>
          </a:ln>
        </p:spPr>
      </p:pic>
      <p:grpSp>
        <p:nvGrpSpPr>
          <p:cNvPr id="643" name=""/>
          <p:cNvGrpSpPr/>
          <p:nvPr/>
        </p:nvGrpSpPr>
        <p:grpSpPr>
          <a:xfrm>
            <a:off x="2160720" y="7922880"/>
            <a:ext cx="2639880" cy="201600"/>
            <a:chOff x="2160720" y="7922880"/>
            <a:chExt cx="2639880" cy="201600"/>
          </a:xfrm>
        </p:grpSpPr>
        <p:sp>
          <p:nvSpPr>
            <p:cNvPr id="644" name=""/>
            <p:cNvSpPr/>
            <p:nvPr/>
          </p:nvSpPr>
          <p:spPr>
            <a:xfrm rot="16200000">
              <a:off x="3499560" y="6820200"/>
              <a:ext cx="198360" cy="240336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"/>
            <p:cNvSpPr/>
            <p:nvPr/>
          </p:nvSpPr>
          <p:spPr>
            <a:xfrm rot="16200000">
              <a:off x="2629800" y="7918920"/>
              <a:ext cx="199440" cy="2113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"/>
            <p:cNvSpPr/>
            <p:nvPr/>
          </p:nvSpPr>
          <p:spPr>
            <a:xfrm rot="16200000">
              <a:off x="3119040" y="7850880"/>
              <a:ext cx="199440" cy="3477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"/>
            <p:cNvSpPr/>
            <p:nvPr/>
          </p:nvSpPr>
          <p:spPr>
            <a:xfrm rot="16200000">
              <a:off x="3561120" y="7977240"/>
              <a:ext cx="199440" cy="950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"/>
            <p:cNvSpPr/>
            <p:nvPr/>
          </p:nvSpPr>
          <p:spPr>
            <a:xfrm rot="16200000">
              <a:off x="4325400" y="7919280"/>
              <a:ext cx="199440" cy="2109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"/>
            <p:cNvSpPr/>
            <p:nvPr/>
          </p:nvSpPr>
          <p:spPr>
            <a:xfrm rot="16200000">
              <a:off x="2256840" y="7961760"/>
              <a:ext cx="143640" cy="11736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"/>
            <p:cNvSpPr/>
            <p:nvPr/>
          </p:nvSpPr>
          <p:spPr>
            <a:xfrm rot="16200000">
              <a:off x="2109960" y="7973640"/>
              <a:ext cx="198360" cy="968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1" name=""/>
          <p:cNvSpPr/>
          <p:nvPr/>
        </p:nvSpPr>
        <p:spPr>
          <a:xfrm>
            <a:off x="2171880" y="7835760"/>
            <a:ext cx="596880" cy="0"/>
          </a:xfrm>
          <a:prstGeom prst="line">
            <a:avLst/>
          </a:prstGeom>
          <a:ln w="381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>
            <a:off x="4145040" y="7835760"/>
            <a:ext cx="690480" cy="0"/>
          </a:xfrm>
          <a:prstGeom prst="line">
            <a:avLst/>
          </a:prstGeom>
          <a:ln w="381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2782800" y="7835760"/>
            <a:ext cx="1346400" cy="0"/>
          </a:xfrm>
          <a:prstGeom prst="line">
            <a:avLst/>
          </a:prstGeom>
          <a:ln w="381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1371600" y="7039080"/>
            <a:ext cx="685800" cy="0"/>
          </a:xfrm>
          <a:prstGeom prst="line">
            <a:avLst/>
          </a:prstGeom>
          <a:ln w="381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>
            <a:off x="4470480" y="7039080"/>
            <a:ext cx="1904760" cy="0"/>
          </a:xfrm>
          <a:prstGeom prst="line">
            <a:avLst/>
          </a:prstGeom>
          <a:ln w="381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"/>
          <p:cNvSpPr/>
          <p:nvPr/>
        </p:nvSpPr>
        <p:spPr>
          <a:xfrm>
            <a:off x="2095560" y="7039080"/>
            <a:ext cx="2336760" cy="0"/>
          </a:xfrm>
          <a:prstGeom prst="line">
            <a:avLst/>
          </a:prstGeom>
          <a:ln w="381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"/>
          <p:cNvSpPr/>
          <p:nvPr/>
        </p:nvSpPr>
        <p:spPr>
          <a:xfrm flipH="1" rot="10800000">
            <a:off x="2031840" y="7051680"/>
            <a:ext cx="76320" cy="169920"/>
          </a:xfrm>
          <a:prstGeom prst="flowChartMerge">
            <a:avLst/>
          </a:prstGeom>
          <a:solidFill>
            <a:srgbClr val="f84e6a"/>
          </a:solidFill>
          <a:ln w="9360">
            <a:solidFill>
              <a:srgbClr val="f84e6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"/>
          <p:cNvSpPr/>
          <p:nvPr/>
        </p:nvSpPr>
        <p:spPr>
          <a:xfrm flipH="1" rot="10800000">
            <a:off x="4418640" y="7051680"/>
            <a:ext cx="75960" cy="169920"/>
          </a:xfrm>
          <a:prstGeom prst="flowChartMerge">
            <a:avLst/>
          </a:prstGeom>
          <a:solidFill>
            <a:srgbClr val="f84e6a"/>
          </a:solidFill>
          <a:ln w="9360">
            <a:solidFill>
              <a:srgbClr val="f84e6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4953240" y="7015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cc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3078000" y="701532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99ff"/>
                </a:solidFill>
                <a:latin typeface="Arial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>
            <a:off x="1884600" y="152280"/>
            <a:ext cx="301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3– difference NLE5-NLE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>
            <a:off x="1783080" y="4343400"/>
            <a:ext cx="316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4– difference NLE22-NLE1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63" name=""/>
          <p:cNvGrpSpPr/>
          <p:nvPr/>
        </p:nvGrpSpPr>
        <p:grpSpPr>
          <a:xfrm>
            <a:off x="1962000" y="3533760"/>
            <a:ext cx="2762280" cy="325080"/>
            <a:chOff x="1962000" y="3533760"/>
            <a:chExt cx="2762280" cy="325080"/>
          </a:xfrm>
        </p:grpSpPr>
        <p:grpSp>
          <p:nvGrpSpPr>
            <p:cNvPr id="664" name=""/>
            <p:cNvGrpSpPr/>
            <p:nvPr/>
          </p:nvGrpSpPr>
          <p:grpSpPr>
            <a:xfrm>
              <a:off x="1982880" y="3657240"/>
              <a:ext cx="2733480" cy="201600"/>
              <a:chOff x="1982880" y="3657240"/>
              <a:chExt cx="2733480" cy="201600"/>
            </a:xfrm>
          </p:grpSpPr>
          <p:sp>
            <p:nvSpPr>
              <p:cNvPr id="665" name=""/>
              <p:cNvSpPr/>
              <p:nvPr/>
            </p:nvSpPr>
            <p:spPr>
              <a:xfrm rot="16200000">
                <a:off x="3369960" y="2506320"/>
                <a:ext cx="195480" cy="2496960"/>
              </a:xfrm>
              <a:prstGeom prst="rect">
                <a:avLst/>
              </a:prstGeom>
              <a:gradFill rotWithShape="0">
                <a:gsLst>
                  <a:gs pos="0">
                    <a:srgbClr val="d9e7fb"/>
                  </a:gs>
                  <a:gs pos="50000">
                    <a:srgbClr val="ffffff"/>
                  </a:gs>
                  <a:gs pos="100000">
                    <a:srgbClr val="d9e7fb"/>
                  </a:gs>
                </a:gsLst>
                <a:lin ang="16200000"/>
              </a:gradFill>
              <a:ln w="9360">
                <a:solidFill>
                  <a:srgbClr val="71bfc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 rot="16200000">
                <a:off x="2636640" y="3706560"/>
                <a:ext cx="195480" cy="9684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 rot="16200000">
                <a:off x="3238200" y="3504960"/>
                <a:ext cx="195480" cy="50004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 rot="16200000">
                <a:off x="3846960" y="3629520"/>
                <a:ext cx="195480" cy="25056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 rot="16200000">
                <a:off x="4306680" y="3677760"/>
                <a:ext cx="195480" cy="15408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 rot="16200000">
                <a:off x="2079000" y="3700800"/>
                <a:ext cx="142200" cy="115920"/>
              </a:xfrm>
              <a:prstGeom prst="rect">
                <a:avLst/>
              </a:prstGeom>
              <a:blipFill rotWithShape="0">
                <a:blip r:embed="rId4"/>
                <a:srcRect/>
                <a:tile tx="0" ty="0" sx="100000" sy="100000" algn="ctr"/>
              </a:blip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"/>
              <p:cNvSpPr/>
              <p:nvPr/>
            </p:nvSpPr>
            <p:spPr>
              <a:xfrm rot="16200000">
                <a:off x="1933560" y="3712680"/>
                <a:ext cx="195480" cy="9684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08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72" name=""/>
            <p:cNvSpPr/>
            <p:nvPr/>
          </p:nvSpPr>
          <p:spPr>
            <a:xfrm>
              <a:off x="1962000" y="3533760"/>
              <a:ext cx="424080" cy="0"/>
            </a:xfrm>
            <a:prstGeom prst="line">
              <a:avLst/>
            </a:prstGeom>
            <a:ln w="381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"/>
            <p:cNvSpPr/>
            <p:nvPr/>
          </p:nvSpPr>
          <p:spPr>
            <a:xfrm>
              <a:off x="2859120" y="3533760"/>
              <a:ext cx="1865160" cy="0"/>
            </a:xfrm>
            <a:prstGeom prst="line">
              <a:avLst/>
            </a:prstGeom>
            <a:ln w="381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"/>
            <p:cNvSpPr/>
            <p:nvPr/>
          </p:nvSpPr>
          <p:spPr>
            <a:xfrm>
              <a:off x="2401920" y="3533760"/>
              <a:ext cx="441360" cy="0"/>
            </a:xfrm>
            <a:prstGeom prst="line">
              <a:avLst/>
            </a:prstGeom>
            <a:ln w="381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5" name=""/>
          <p:cNvSpPr/>
          <p:nvPr/>
        </p:nvSpPr>
        <p:spPr>
          <a:xfrm>
            <a:off x="2057040" y="3297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"/>
          <p:cNvSpPr/>
          <p:nvPr/>
        </p:nvSpPr>
        <p:spPr>
          <a:xfrm>
            <a:off x="3568320" y="3292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cc33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"/>
          <p:cNvSpPr/>
          <p:nvPr/>
        </p:nvSpPr>
        <p:spPr>
          <a:xfrm>
            <a:off x="2463120" y="3297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cc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"/>
          <p:cNvSpPr/>
          <p:nvPr/>
        </p:nvSpPr>
        <p:spPr>
          <a:xfrm>
            <a:off x="1562400" y="7015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cc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"/>
          <p:cNvSpPr/>
          <p:nvPr/>
        </p:nvSpPr>
        <p:spPr>
          <a:xfrm>
            <a:off x="2327760" y="75866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cc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"/>
          <p:cNvSpPr/>
          <p:nvPr/>
        </p:nvSpPr>
        <p:spPr>
          <a:xfrm>
            <a:off x="4296240" y="75819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cc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"/>
          <p:cNvSpPr/>
          <p:nvPr/>
        </p:nvSpPr>
        <p:spPr>
          <a:xfrm>
            <a:off x="3217680" y="759924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99ff"/>
                </a:solidFill>
                <a:latin typeface="Arial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"/>
          <p:cNvSpPr/>
          <p:nvPr/>
        </p:nvSpPr>
        <p:spPr>
          <a:xfrm>
            <a:off x="2298960" y="3798720"/>
            <a:ext cx="21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1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"/>
          <p:cNvSpPr/>
          <p:nvPr/>
        </p:nvSpPr>
        <p:spPr>
          <a:xfrm>
            <a:off x="2374920" y="8078760"/>
            <a:ext cx="21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1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4" name="" descr=""/>
          <p:cNvPicPr/>
          <p:nvPr/>
        </p:nvPicPr>
        <p:blipFill>
          <a:blip r:embed="rId1"/>
          <a:stretch/>
        </p:blipFill>
        <p:spPr>
          <a:xfrm>
            <a:off x="457200" y="449280"/>
            <a:ext cx="5943600" cy="2514600"/>
          </a:xfrm>
          <a:prstGeom prst="rect">
            <a:avLst/>
          </a:prstGeom>
          <a:ln w="0">
            <a:noFill/>
          </a:ln>
        </p:spPr>
      </p:pic>
      <p:sp>
        <p:nvSpPr>
          <p:cNvPr id="685" name=""/>
          <p:cNvSpPr/>
          <p:nvPr/>
        </p:nvSpPr>
        <p:spPr>
          <a:xfrm>
            <a:off x="1878120" y="334800"/>
            <a:ext cx="308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6– difference NLE18-NLE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"/>
          <p:cNvSpPr/>
          <p:nvPr/>
        </p:nvSpPr>
        <p:spPr>
          <a:xfrm>
            <a:off x="647640" y="2506680"/>
            <a:ext cx="118116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"/>
          <p:cNvSpPr/>
          <p:nvPr/>
        </p:nvSpPr>
        <p:spPr>
          <a:xfrm>
            <a:off x="1854360" y="2506680"/>
            <a:ext cx="4419360" cy="0"/>
          </a:xfrm>
          <a:prstGeom prst="line">
            <a:avLst/>
          </a:prstGeom>
          <a:ln w="381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"/>
          <p:cNvSpPr/>
          <p:nvPr/>
        </p:nvSpPr>
        <p:spPr>
          <a:xfrm flipH="1" rot="10800000">
            <a:off x="1803240" y="2531880"/>
            <a:ext cx="76320" cy="16956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"/>
          <p:cNvSpPr/>
          <p:nvPr/>
        </p:nvSpPr>
        <p:spPr>
          <a:xfrm>
            <a:off x="1105200" y="24638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"/>
          <p:cNvSpPr/>
          <p:nvPr/>
        </p:nvSpPr>
        <p:spPr>
          <a:xfrm>
            <a:off x="3161880" y="24811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33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"/>
          <p:cNvSpPr/>
          <p:nvPr/>
        </p:nvSpPr>
        <p:spPr>
          <a:xfrm>
            <a:off x="2425680" y="792000"/>
            <a:ext cx="457200" cy="76320"/>
          </a:xfrm>
          <a:prstGeom prst="rect">
            <a:avLst/>
          </a:prstGeom>
          <a:solidFill>
            <a:srgbClr val="35f735"/>
          </a:solidFill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"/>
          <p:cNvSpPr/>
          <p:nvPr/>
        </p:nvSpPr>
        <p:spPr>
          <a:xfrm>
            <a:off x="4660920" y="690480"/>
            <a:ext cx="152280" cy="76320"/>
          </a:xfrm>
          <a:prstGeom prst="rect">
            <a:avLst/>
          </a:prstGeom>
          <a:solidFill>
            <a:srgbClr val="35f735"/>
          </a:solidFill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"/>
          <p:cNvSpPr/>
          <p:nvPr/>
        </p:nvSpPr>
        <p:spPr>
          <a:xfrm>
            <a:off x="4765320" y="598320"/>
            <a:ext cx="153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egmental duplic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4" name="" descr=""/>
          <p:cNvPicPr/>
          <p:nvPr/>
        </p:nvPicPr>
        <p:blipFill>
          <a:blip r:embed="rId2"/>
          <a:stretch/>
        </p:blipFill>
        <p:spPr>
          <a:xfrm>
            <a:off x="317520" y="4419720"/>
            <a:ext cx="6311880" cy="2733480"/>
          </a:xfrm>
          <a:prstGeom prst="rect">
            <a:avLst/>
          </a:prstGeom>
          <a:ln w="0">
            <a:noFill/>
          </a:ln>
        </p:spPr>
      </p:pic>
      <p:sp>
        <p:nvSpPr>
          <p:cNvPr id="695" name=""/>
          <p:cNvSpPr/>
          <p:nvPr/>
        </p:nvSpPr>
        <p:spPr>
          <a:xfrm>
            <a:off x="569880" y="6791400"/>
            <a:ext cx="116064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"/>
          <p:cNvSpPr/>
          <p:nvPr/>
        </p:nvSpPr>
        <p:spPr>
          <a:xfrm flipH="1">
            <a:off x="2273400" y="6791400"/>
            <a:ext cx="34272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"/>
          <p:cNvSpPr/>
          <p:nvPr/>
        </p:nvSpPr>
        <p:spPr>
          <a:xfrm>
            <a:off x="2868480" y="6791400"/>
            <a:ext cx="117972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"/>
          <p:cNvSpPr/>
          <p:nvPr/>
        </p:nvSpPr>
        <p:spPr>
          <a:xfrm flipH="1">
            <a:off x="4927320" y="6789600"/>
            <a:ext cx="32868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"/>
          <p:cNvSpPr/>
          <p:nvPr/>
        </p:nvSpPr>
        <p:spPr>
          <a:xfrm>
            <a:off x="1752480" y="6791400"/>
            <a:ext cx="49860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"/>
          <p:cNvSpPr/>
          <p:nvPr/>
        </p:nvSpPr>
        <p:spPr>
          <a:xfrm>
            <a:off x="2629080" y="6791400"/>
            <a:ext cx="21888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"/>
          <p:cNvSpPr/>
          <p:nvPr/>
        </p:nvSpPr>
        <p:spPr>
          <a:xfrm>
            <a:off x="4064040" y="6786720"/>
            <a:ext cx="84132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"/>
          <p:cNvSpPr/>
          <p:nvPr/>
        </p:nvSpPr>
        <p:spPr>
          <a:xfrm>
            <a:off x="5283360" y="6791400"/>
            <a:ext cx="116820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"/>
          <p:cNvSpPr/>
          <p:nvPr/>
        </p:nvSpPr>
        <p:spPr>
          <a:xfrm flipH="1" rot="10800000">
            <a:off x="1701720" y="681660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"/>
          <p:cNvSpPr/>
          <p:nvPr/>
        </p:nvSpPr>
        <p:spPr>
          <a:xfrm flipH="1" rot="10800000">
            <a:off x="2221560" y="6816600"/>
            <a:ext cx="7596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"/>
          <p:cNvSpPr/>
          <p:nvPr/>
        </p:nvSpPr>
        <p:spPr>
          <a:xfrm flipH="1" rot="10800000">
            <a:off x="2577960" y="681660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"/>
          <p:cNvSpPr/>
          <p:nvPr/>
        </p:nvSpPr>
        <p:spPr>
          <a:xfrm flipH="1" rot="10800000">
            <a:off x="2818440" y="6816600"/>
            <a:ext cx="7596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"/>
          <p:cNvSpPr/>
          <p:nvPr/>
        </p:nvSpPr>
        <p:spPr>
          <a:xfrm flipH="1" rot="10800000">
            <a:off x="4012200" y="6816600"/>
            <a:ext cx="7596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"/>
          <p:cNvSpPr/>
          <p:nvPr/>
        </p:nvSpPr>
        <p:spPr>
          <a:xfrm flipH="1" rot="10800000">
            <a:off x="4875840" y="6829200"/>
            <a:ext cx="75960" cy="16956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"/>
          <p:cNvSpPr/>
          <p:nvPr/>
        </p:nvSpPr>
        <p:spPr>
          <a:xfrm flipH="1" rot="10800000">
            <a:off x="5244120" y="6829200"/>
            <a:ext cx="75960" cy="16956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"/>
          <p:cNvSpPr/>
          <p:nvPr/>
        </p:nvSpPr>
        <p:spPr>
          <a:xfrm>
            <a:off x="952920" y="6756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1bfc5"/>
                </a:solidFill>
                <a:latin typeface="Arial"/>
              </a:rPr>
              <a:t>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"/>
          <p:cNvSpPr/>
          <p:nvPr/>
        </p:nvSpPr>
        <p:spPr>
          <a:xfrm>
            <a:off x="2252880" y="6756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1bfc5"/>
                </a:solidFill>
                <a:latin typeface="Arial"/>
              </a:rPr>
              <a:t>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"/>
          <p:cNvSpPr/>
          <p:nvPr/>
        </p:nvSpPr>
        <p:spPr>
          <a:xfrm>
            <a:off x="3305520" y="6756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1bfc5"/>
                </a:solidFill>
                <a:latin typeface="Arial"/>
              </a:rPr>
              <a:t>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"/>
          <p:cNvSpPr/>
          <p:nvPr/>
        </p:nvSpPr>
        <p:spPr>
          <a:xfrm>
            <a:off x="4910400" y="6756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1bfc5"/>
                </a:solidFill>
                <a:latin typeface="Arial"/>
              </a:rPr>
              <a:t>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"/>
          <p:cNvSpPr/>
          <p:nvPr/>
        </p:nvSpPr>
        <p:spPr>
          <a:xfrm>
            <a:off x="1781640" y="6756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046dc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"/>
          <p:cNvSpPr/>
          <p:nvPr/>
        </p:nvSpPr>
        <p:spPr>
          <a:xfrm>
            <a:off x="2543400" y="65642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046dc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"/>
          <p:cNvSpPr/>
          <p:nvPr/>
        </p:nvSpPr>
        <p:spPr>
          <a:xfrm>
            <a:off x="4267440" y="6756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046dc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"/>
          <p:cNvSpPr/>
          <p:nvPr/>
        </p:nvSpPr>
        <p:spPr>
          <a:xfrm>
            <a:off x="5681880" y="6756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046dc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"/>
          <p:cNvSpPr/>
          <p:nvPr/>
        </p:nvSpPr>
        <p:spPr>
          <a:xfrm>
            <a:off x="1872000" y="4305240"/>
            <a:ext cx="315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7– difference NLE14-NLE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9" name=""/>
          <p:cNvGrpSpPr/>
          <p:nvPr/>
        </p:nvGrpSpPr>
        <p:grpSpPr>
          <a:xfrm>
            <a:off x="2057400" y="3335040"/>
            <a:ext cx="2593440" cy="201960"/>
            <a:chOff x="2057400" y="3335040"/>
            <a:chExt cx="2593440" cy="201960"/>
          </a:xfrm>
        </p:grpSpPr>
        <p:sp>
          <p:nvSpPr>
            <p:cNvPr id="720" name=""/>
            <p:cNvSpPr/>
            <p:nvPr/>
          </p:nvSpPr>
          <p:spPr>
            <a:xfrm rot="16200000">
              <a:off x="2543760" y="2848680"/>
              <a:ext cx="201600" cy="117468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"/>
            <p:cNvSpPr/>
            <p:nvPr/>
          </p:nvSpPr>
          <p:spPr>
            <a:xfrm rot="16200000">
              <a:off x="3910320" y="2796480"/>
              <a:ext cx="201600" cy="127908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"/>
            <p:cNvSpPr/>
            <p:nvPr/>
          </p:nvSpPr>
          <p:spPr>
            <a:xfrm rot="16200000">
              <a:off x="2163960" y="3361680"/>
              <a:ext cx="201600" cy="1486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"/>
            <p:cNvSpPr/>
            <p:nvPr/>
          </p:nvSpPr>
          <p:spPr>
            <a:xfrm rot="16200000">
              <a:off x="2562480" y="3318840"/>
              <a:ext cx="201600" cy="2343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"/>
            <p:cNvSpPr/>
            <p:nvPr/>
          </p:nvSpPr>
          <p:spPr>
            <a:xfrm rot="16200000">
              <a:off x="3688560" y="3400200"/>
              <a:ext cx="194040" cy="633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6560" bIns="16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"/>
            <p:cNvSpPr/>
            <p:nvPr/>
          </p:nvSpPr>
          <p:spPr>
            <a:xfrm flipV="1" rot="16200000">
              <a:off x="3398760" y="3307680"/>
              <a:ext cx="201600" cy="256680"/>
            </a:xfrm>
            <a:prstGeom prst="rect">
              <a:avLst/>
            </a:prstGeom>
            <a:gradFill rotWithShape="0">
              <a:gsLst>
                <a:gs pos="0">
                  <a:srgbClr val="000000"/>
                </a:gs>
                <a:gs pos="50000">
                  <a:srgbClr val="b2b2b2"/>
                </a:gs>
                <a:gs pos="100000">
                  <a:srgbClr val="000000"/>
                </a:gs>
              </a:gsLst>
              <a:lin ang="5400000"/>
            </a:gradFill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"/>
            <p:cNvSpPr/>
            <p:nvPr/>
          </p:nvSpPr>
          <p:spPr>
            <a:xfrm rot="16200000">
              <a:off x="3937320" y="3361680"/>
              <a:ext cx="201600" cy="1490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"/>
            <p:cNvSpPr/>
            <p:nvPr/>
          </p:nvSpPr>
          <p:spPr>
            <a:xfrm rot="16200000">
              <a:off x="4293720" y="3362400"/>
              <a:ext cx="201600" cy="1472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"/>
            <p:cNvSpPr/>
            <p:nvPr/>
          </p:nvSpPr>
          <p:spPr>
            <a:xfrm rot="16200000">
              <a:off x="3226320" y="3368520"/>
              <a:ext cx="146880" cy="12996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9" name=""/>
          <p:cNvSpPr/>
          <p:nvPr/>
        </p:nvSpPr>
        <p:spPr>
          <a:xfrm>
            <a:off x="2062080" y="3263760"/>
            <a:ext cx="53352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"/>
          <p:cNvSpPr/>
          <p:nvPr/>
        </p:nvSpPr>
        <p:spPr>
          <a:xfrm>
            <a:off x="2624040" y="3263760"/>
            <a:ext cx="2049480" cy="0"/>
          </a:xfrm>
          <a:prstGeom prst="line">
            <a:avLst/>
          </a:prstGeom>
          <a:ln w="381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"/>
          <p:cNvSpPr/>
          <p:nvPr/>
        </p:nvSpPr>
        <p:spPr>
          <a:xfrm>
            <a:off x="2136960" y="30272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"/>
          <p:cNvSpPr/>
          <p:nvPr/>
        </p:nvSpPr>
        <p:spPr>
          <a:xfrm>
            <a:off x="3466440" y="3027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33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"/>
          <p:cNvSpPr/>
          <p:nvPr/>
        </p:nvSpPr>
        <p:spPr>
          <a:xfrm rot="16200000">
            <a:off x="2514600" y="7342200"/>
            <a:ext cx="201600" cy="811440"/>
          </a:xfrm>
          <a:prstGeom prst="rect">
            <a:avLst/>
          </a:prstGeom>
          <a:gradFill rotWithShape="0">
            <a:gsLst>
              <a:gs pos="0">
                <a:srgbClr val="d9e7fb"/>
              </a:gs>
              <a:gs pos="50000">
                <a:srgbClr val="ffffff"/>
              </a:gs>
              <a:gs pos="100000">
                <a:srgbClr val="d9e7fb"/>
              </a:gs>
            </a:gsLst>
            <a:lin ang="16200000"/>
          </a:gradFill>
          <a:ln w="93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"/>
          <p:cNvSpPr/>
          <p:nvPr/>
        </p:nvSpPr>
        <p:spPr>
          <a:xfrm rot="16200000">
            <a:off x="3816360" y="6984720"/>
            <a:ext cx="199800" cy="1523880"/>
          </a:xfrm>
          <a:prstGeom prst="rect">
            <a:avLst/>
          </a:prstGeom>
          <a:gradFill rotWithShape="0">
            <a:gsLst>
              <a:gs pos="0">
                <a:srgbClr val="d9e7fb"/>
              </a:gs>
              <a:gs pos="50000">
                <a:srgbClr val="ffffff"/>
              </a:gs>
              <a:gs pos="100000">
                <a:srgbClr val="d9e7fb"/>
              </a:gs>
            </a:gsLst>
            <a:lin ang="16200000"/>
          </a:gradFill>
          <a:ln w="93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"/>
          <p:cNvSpPr/>
          <p:nvPr/>
        </p:nvSpPr>
        <p:spPr>
          <a:xfrm rot="16200000">
            <a:off x="2530440" y="7637400"/>
            <a:ext cx="201600" cy="22068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"/>
          <p:cNvSpPr/>
          <p:nvPr/>
        </p:nvSpPr>
        <p:spPr>
          <a:xfrm rot="16200000">
            <a:off x="3439440" y="7664760"/>
            <a:ext cx="199800" cy="16380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"/>
          <p:cNvSpPr/>
          <p:nvPr/>
        </p:nvSpPr>
        <p:spPr>
          <a:xfrm rot="16200000">
            <a:off x="3914640" y="7654320"/>
            <a:ext cx="199800" cy="18432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"/>
          <p:cNvSpPr/>
          <p:nvPr/>
        </p:nvSpPr>
        <p:spPr>
          <a:xfrm rot="16200000">
            <a:off x="4240080" y="7654320"/>
            <a:ext cx="199800" cy="18432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"/>
          <p:cNvSpPr/>
          <p:nvPr/>
        </p:nvSpPr>
        <p:spPr>
          <a:xfrm rot="16200000">
            <a:off x="3015360" y="7685280"/>
            <a:ext cx="145800" cy="12240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"/>
          <p:cNvSpPr/>
          <p:nvPr/>
        </p:nvSpPr>
        <p:spPr>
          <a:xfrm>
            <a:off x="2214720" y="7586640"/>
            <a:ext cx="48420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"/>
          <p:cNvSpPr/>
          <p:nvPr/>
        </p:nvSpPr>
        <p:spPr>
          <a:xfrm>
            <a:off x="2712960" y="7586640"/>
            <a:ext cx="38412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"/>
          <p:cNvSpPr/>
          <p:nvPr/>
        </p:nvSpPr>
        <p:spPr>
          <a:xfrm>
            <a:off x="3111480" y="7586640"/>
            <a:ext cx="24300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"/>
          <p:cNvSpPr/>
          <p:nvPr/>
        </p:nvSpPr>
        <p:spPr>
          <a:xfrm>
            <a:off x="3365640" y="7586640"/>
            <a:ext cx="20448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"/>
          <p:cNvSpPr/>
          <p:nvPr/>
        </p:nvSpPr>
        <p:spPr>
          <a:xfrm>
            <a:off x="3579840" y="7586640"/>
            <a:ext cx="28584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"/>
          <p:cNvSpPr/>
          <p:nvPr/>
        </p:nvSpPr>
        <p:spPr>
          <a:xfrm>
            <a:off x="3876840" y="7586640"/>
            <a:ext cx="30312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"/>
          <p:cNvSpPr/>
          <p:nvPr/>
        </p:nvSpPr>
        <p:spPr>
          <a:xfrm>
            <a:off x="4194000" y="7586640"/>
            <a:ext cx="16200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"/>
          <p:cNvSpPr/>
          <p:nvPr/>
        </p:nvSpPr>
        <p:spPr>
          <a:xfrm>
            <a:off x="4365720" y="7586640"/>
            <a:ext cx="32544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"/>
          <p:cNvSpPr/>
          <p:nvPr/>
        </p:nvSpPr>
        <p:spPr>
          <a:xfrm>
            <a:off x="2268360" y="7385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71bfc5"/>
                </a:solidFill>
                <a:latin typeface="Arial"/>
              </a:rPr>
              <a:t>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"/>
          <p:cNvSpPr/>
          <p:nvPr/>
        </p:nvSpPr>
        <p:spPr>
          <a:xfrm>
            <a:off x="3055680" y="7385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71bfc5"/>
                </a:solidFill>
                <a:latin typeface="Arial"/>
              </a:rPr>
              <a:t>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"/>
          <p:cNvSpPr/>
          <p:nvPr/>
        </p:nvSpPr>
        <p:spPr>
          <a:xfrm>
            <a:off x="3544920" y="7385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71bfc5"/>
                </a:solidFill>
                <a:latin typeface="Arial"/>
              </a:rPr>
              <a:t>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"/>
          <p:cNvSpPr/>
          <p:nvPr/>
        </p:nvSpPr>
        <p:spPr>
          <a:xfrm>
            <a:off x="4097160" y="7385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71bfc5"/>
                </a:solidFill>
                <a:latin typeface="Arial"/>
              </a:rPr>
              <a:t>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"/>
          <p:cNvSpPr/>
          <p:nvPr/>
        </p:nvSpPr>
        <p:spPr>
          <a:xfrm>
            <a:off x="2712960" y="7385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046dc"/>
                </a:solidFill>
                <a:latin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"/>
          <p:cNvSpPr/>
          <p:nvPr/>
        </p:nvSpPr>
        <p:spPr>
          <a:xfrm>
            <a:off x="3284280" y="7385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046dc"/>
                </a:solidFill>
                <a:latin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"/>
          <p:cNvSpPr/>
          <p:nvPr/>
        </p:nvSpPr>
        <p:spPr>
          <a:xfrm>
            <a:off x="3855960" y="7385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046dc"/>
                </a:solidFill>
                <a:latin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"/>
          <p:cNvSpPr/>
          <p:nvPr/>
        </p:nvSpPr>
        <p:spPr>
          <a:xfrm>
            <a:off x="4344840" y="7385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046dc"/>
                </a:solidFill>
                <a:latin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"/>
          <p:cNvSpPr/>
          <p:nvPr/>
        </p:nvSpPr>
        <p:spPr>
          <a:xfrm>
            <a:off x="2298960" y="3481560"/>
            <a:ext cx="21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1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"/>
          <p:cNvSpPr/>
          <p:nvPr/>
        </p:nvSpPr>
        <p:spPr>
          <a:xfrm>
            <a:off x="2362320" y="7805880"/>
            <a:ext cx="21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8" name="" descr=""/>
          <p:cNvPicPr/>
          <p:nvPr/>
        </p:nvPicPr>
        <p:blipFill>
          <a:blip r:embed="rId1"/>
          <a:stretch/>
        </p:blipFill>
        <p:spPr>
          <a:xfrm>
            <a:off x="330120" y="177840"/>
            <a:ext cx="6248520" cy="2514600"/>
          </a:xfrm>
          <a:prstGeom prst="rect">
            <a:avLst/>
          </a:prstGeom>
          <a:ln w="0">
            <a:noFill/>
          </a:ln>
        </p:spPr>
      </p:pic>
      <p:sp>
        <p:nvSpPr>
          <p:cNvPr id="759" name=""/>
          <p:cNvSpPr/>
          <p:nvPr/>
        </p:nvSpPr>
        <p:spPr>
          <a:xfrm>
            <a:off x="1872000" y="88920"/>
            <a:ext cx="315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9– difference NLE10-NLE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"/>
          <p:cNvSpPr/>
          <p:nvPr/>
        </p:nvSpPr>
        <p:spPr>
          <a:xfrm>
            <a:off x="609480" y="2209680"/>
            <a:ext cx="3886200" cy="0"/>
          </a:xfrm>
          <a:prstGeom prst="line">
            <a:avLst/>
          </a:prstGeom>
          <a:ln w="38160">
            <a:solidFill>
              <a:srgbClr val="99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"/>
          <p:cNvSpPr/>
          <p:nvPr/>
        </p:nvSpPr>
        <p:spPr>
          <a:xfrm>
            <a:off x="5295960" y="2209680"/>
            <a:ext cx="1104840" cy="0"/>
          </a:xfrm>
          <a:prstGeom prst="line">
            <a:avLst/>
          </a:prstGeom>
          <a:ln w="38160">
            <a:solidFill>
              <a:srgbClr val="99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"/>
          <p:cNvSpPr/>
          <p:nvPr/>
        </p:nvSpPr>
        <p:spPr>
          <a:xfrm>
            <a:off x="4521240" y="2209680"/>
            <a:ext cx="73656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"/>
          <p:cNvSpPr/>
          <p:nvPr/>
        </p:nvSpPr>
        <p:spPr>
          <a:xfrm flipH="1" rot="10800000">
            <a:off x="4469400" y="2235240"/>
            <a:ext cx="7596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"/>
          <p:cNvSpPr/>
          <p:nvPr/>
        </p:nvSpPr>
        <p:spPr>
          <a:xfrm flipH="1" rot="10800000">
            <a:off x="5232240" y="223524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5" name="" descr=""/>
          <p:cNvPicPr/>
          <p:nvPr/>
        </p:nvPicPr>
        <p:blipFill>
          <a:blip r:embed="rId2"/>
          <a:stretch/>
        </p:blipFill>
        <p:spPr>
          <a:xfrm>
            <a:off x="291960" y="4214880"/>
            <a:ext cx="6324840" cy="2998800"/>
          </a:xfrm>
          <a:prstGeom prst="rect">
            <a:avLst/>
          </a:prstGeom>
          <a:ln w="0">
            <a:noFill/>
          </a:ln>
        </p:spPr>
      </p:pic>
      <p:sp>
        <p:nvSpPr>
          <p:cNvPr id="766" name=""/>
          <p:cNvSpPr/>
          <p:nvPr/>
        </p:nvSpPr>
        <p:spPr>
          <a:xfrm>
            <a:off x="1884600" y="4125960"/>
            <a:ext cx="315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20– difference NLE11-NLE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7" name=""/>
          <p:cNvGrpSpPr/>
          <p:nvPr/>
        </p:nvGrpSpPr>
        <p:grpSpPr>
          <a:xfrm>
            <a:off x="2440080" y="7647120"/>
            <a:ext cx="2019240" cy="201600"/>
            <a:chOff x="2440080" y="7647120"/>
            <a:chExt cx="2019240" cy="201600"/>
          </a:xfrm>
        </p:grpSpPr>
        <p:sp>
          <p:nvSpPr>
            <p:cNvPr id="768" name=""/>
            <p:cNvSpPr/>
            <p:nvPr/>
          </p:nvSpPr>
          <p:spPr>
            <a:xfrm rot="16200000">
              <a:off x="2801880" y="7284960"/>
              <a:ext cx="201600" cy="92556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"/>
            <p:cNvSpPr/>
            <p:nvPr/>
          </p:nvSpPr>
          <p:spPr>
            <a:xfrm rot="16200000">
              <a:off x="3895560" y="7284960"/>
              <a:ext cx="201600" cy="92556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"/>
            <p:cNvSpPr/>
            <p:nvPr/>
          </p:nvSpPr>
          <p:spPr>
            <a:xfrm rot="16200000">
              <a:off x="2779560" y="7585200"/>
              <a:ext cx="201600" cy="3254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"/>
            <p:cNvSpPr/>
            <p:nvPr/>
          </p:nvSpPr>
          <p:spPr>
            <a:xfrm rot="16200000">
              <a:off x="3767040" y="7621560"/>
              <a:ext cx="201600" cy="2523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"/>
            <p:cNvSpPr/>
            <p:nvPr/>
          </p:nvSpPr>
          <p:spPr>
            <a:xfrm rot="16200000">
              <a:off x="4121640" y="7684200"/>
              <a:ext cx="201600" cy="1270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"/>
            <p:cNvSpPr/>
            <p:nvPr/>
          </p:nvSpPr>
          <p:spPr>
            <a:xfrm rot="16200000">
              <a:off x="3377520" y="7671240"/>
              <a:ext cx="145800" cy="15372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74" name=""/>
          <p:cNvSpPr/>
          <p:nvPr/>
        </p:nvSpPr>
        <p:spPr>
          <a:xfrm>
            <a:off x="2424240" y="7569360"/>
            <a:ext cx="32544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"/>
          <p:cNvSpPr/>
          <p:nvPr/>
        </p:nvSpPr>
        <p:spPr>
          <a:xfrm>
            <a:off x="3032280" y="7569360"/>
            <a:ext cx="145080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"/>
          <p:cNvSpPr/>
          <p:nvPr/>
        </p:nvSpPr>
        <p:spPr>
          <a:xfrm>
            <a:off x="2760840" y="7569360"/>
            <a:ext cx="25236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"/>
          <p:cNvSpPr/>
          <p:nvPr/>
        </p:nvSpPr>
        <p:spPr>
          <a:xfrm>
            <a:off x="622440" y="6821640"/>
            <a:ext cx="44424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"/>
          <p:cNvSpPr/>
          <p:nvPr/>
        </p:nvSpPr>
        <p:spPr>
          <a:xfrm>
            <a:off x="2070000" y="6821640"/>
            <a:ext cx="403884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9" name=""/>
          <p:cNvSpPr/>
          <p:nvPr/>
        </p:nvSpPr>
        <p:spPr>
          <a:xfrm>
            <a:off x="1092240" y="6821640"/>
            <a:ext cx="96516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"/>
          <p:cNvSpPr/>
          <p:nvPr/>
        </p:nvSpPr>
        <p:spPr>
          <a:xfrm flipH="1" rot="10800000">
            <a:off x="1054080" y="683424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"/>
          <p:cNvSpPr/>
          <p:nvPr/>
        </p:nvSpPr>
        <p:spPr>
          <a:xfrm flipH="1" rot="10800000">
            <a:off x="2019240" y="683424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"/>
          <p:cNvSpPr/>
          <p:nvPr/>
        </p:nvSpPr>
        <p:spPr>
          <a:xfrm>
            <a:off x="2324520" y="2163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0099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"/>
          <p:cNvSpPr/>
          <p:nvPr/>
        </p:nvSpPr>
        <p:spPr>
          <a:xfrm>
            <a:off x="5667840" y="2163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0099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"/>
          <p:cNvSpPr/>
          <p:nvPr/>
        </p:nvSpPr>
        <p:spPr>
          <a:xfrm>
            <a:off x="4705560" y="2163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"/>
          <p:cNvSpPr/>
          <p:nvPr/>
        </p:nvSpPr>
        <p:spPr>
          <a:xfrm>
            <a:off x="686160" y="67802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c7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6" name=""/>
          <p:cNvSpPr/>
          <p:nvPr/>
        </p:nvSpPr>
        <p:spPr>
          <a:xfrm>
            <a:off x="2810160" y="67928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c7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"/>
          <p:cNvSpPr/>
          <p:nvPr/>
        </p:nvSpPr>
        <p:spPr>
          <a:xfrm>
            <a:off x="1400400" y="67676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8" name=""/>
          <p:cNvGrpSpPr/>
          <p:nvPr/>
        </p:nvGrpSpPr>
        <p:grpSpPr>
          <a:xfrm>
            <a:off x="2362320" y="2741760"/>
            <a:ext cx="2235240" cy="501480"/>
            <a:chOff x="2362320" y="2741760"/>
            <a:chExt cx="2235240" cy="501480"/>
          </a:xfrm>
        </p:grpSpPr>
        <p:sp>
          <p:nvSpPr>
            <p:cNvPr id="789" name=""/>
            <p:cNvSpPr/>
            <p:nvPr/>
          </p:nvSpPr>
          <p:spPr>
            <a:xfrm>
              <a:off x="3921480" y="274320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2d8f4b"/>
                  </a:solidFill>
                  <a:latin typeface="Arial"/>
                </a:rPr>
                <a:t>1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"/>
            <p:cNvSpPr/>
            <p:nvPr/>
          </p:nvSpPr>
          <p:spPr>
            <a:xfrm>
              <a:off x="3013560" y="27417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990099"/>
                  </a:solidFill>
                  <a:latin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91" name=""/>
            <p:cNvGrpSpPr/>
            <p:nvPr/>
          </p:nvGrpSpPr>
          <p:grpSpPr>
            <a:xfrm>
              <a:off x="2365200" y="3041640"/>
              <a:ext cx="2219400" cy="201600"/>
              <a:chOff x="2365200" y="3041640"/>
              <a:chExt cx="2219400" cy="201600"/>
            </a:xfrm>
          </p:grpSpPr>
          <p:sp>
            <p:nvSpPr>
              <p:cNvPr id="792" name=""/>
              <p:cNvSpPr/>
              <p:nvPr/>
            </p:nvSpPr>
            <p:spPr>
              <a:xfrm rot="16200000">
                <a:off x="2779560" y="2627280"/>
                <a:ext cx="201600" cy="1030320"/>
              </a:xfrm>
              <a:prstGeom prst="rect">
                <a:avLst/>
              </a:prstGeom>
              <a:gradFill rotWithShape="0">
                <a:gsLst>
                  <a:gs pos="0">
                    <a:srgbClr val="d9e7fb"/>
                  </a:gs>
                  <a:gs pos="50000">
                    <a:srgbClr val="ffffff"/>
                  </a:gs>
                  <a:gs pos="100000">
                    <a:srgbClr val="d9e7fb"/>
                  </a:gs>
                </a:gsLst>
                <a:lin ang="16200000"/>
              </a:gradFill>
              <a:ln w="9360">
                <a:solidFill>
                  <a:srgbClr val="71bfc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"/>
              <p:cNvSpPr/>
              <p:nvPr/>
            </p:nvSpPr>
            <p:spPr>
              <a:xfrm rot="16200000">
                <a:off x="3962160" y="2627280"/>
                <a:ext cx="201600" cy="1030320"/>
              </a:xfrm>
              <a:prstGeom prst="rect">
                <a:avLst/>
              </a:prstGeom>
              <a:gradFill rotWithShape="0">
                <a:gsLst>
                  <a:gs pos="0">
                    <a:srgbClr val="d9e7fb"/>
                  </a:gs>
                  <a:gs pos="50000">
                    <a:srgbClr val="ffffff"/>
                  </a:gs>
                  <a:gs pos="100000">
                    <a:srgbClr val="d9e7fb"/>
                  </a:gs>
                </a:gsLst>
                <a:lin ang="16200000"/>
              </a:gradFill>
              <a:ln w="9360">
                <a:solidFill>
                  <a:srgbClr val="71bfc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"/>
              <p:cNvSpPr/>
              <p:nvPr/>
            </p:nvSpPr>
            <p:spPr>
              <a:xfrm rot="16200000">
                <a:off x="2851200" y="3049560"/>
                <a:ext cx="201600" cy="18576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"/>
              <p:cNvSpPr/>
              <p:nvPr/>
            </p:nvSpPr>
            <p:spPr>
              <a:xfrm flipV="1" rot="16200000">
                <a:off x="3220200" y="3060000"/>
                <a:ext cx="201600" cy="1648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b2b2b2"/>
                  </a:gs>
                  <a:gs pos="100000">
                    <a:srgbClr val="000000"/>
                  </a:gs>
                </a:gsLst>
                <a:lin ang="5400000"/>
              </a:gra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"/>
              <p:cNvSpPr/>
              <p:nvPr/>
            </p:nvSpPr>
            <p:spPr>
              <a:xfrm flipV="1" rot="16200000">
                <a:off x="3551040" y="3038400"/>
                <a:ext cx="201600" cy="2080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b2b2b2"/>
                  </a:gs>
                  <a:gs pos="100000">
                    <a:srgbClr val="000000"/>
                  </a:gs>
                </a:gsLst>
                <a:lin ang="5400000"/>
              </a:gra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"/>
              <p:cNvSpPr/>
              <p:nvPr/>
            </p:nvSpPr>
            <p:spPr>
              <a:xfrm rot="16200000">
                <a:off x="3986640" y="3059640"/>
                <a:ext cx="201600" cy="16524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"/>
              <p:cNvSpPr/>
              <p:nvPr/>
            </p:nvSpPr>
            <p:spPr>
              <a:xfrm rot="16200000">
                <a:off x="4401000" y="3059640"/>
                <a:ext cx="201600" cy="16524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"/>
              <p:cNvSpPr/>
              <p:nvPr/>
            </p:nvSpPr>
            <p:spPr>
              <a:xfrm rot="16200000">
                <a:off x="3403800" y="3082320"/>
                <a:ext cx="145440" cy="123840"/>
              </a:xfrm>
              <a:prstGeom prst="rect">
                <a:avLst/>
              </a:prstGeom>
              <a:blipFill rotWithShape="0">
                <a:blip r:embed="rId4"/>
                <a:srcRect/>
                <a:tile tx="0" ty="0" sx="100000" sy="100000" algn="ctr"/>
              </a:blip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00" name=""/>
            <p:cNvSpPr/>
            <p:nvPr/>
          </p:nvSpPr>
          <p:spPr>
            <a:xfrm>
              <a:off x="2362320" y="2971800"/>
              <a:ext cx="1608120" cy="0"/>
            </a:xfrm>
            <a:prstGeom prst="line">
              <a:avLst/>
            </a:prstGeom>
            <a:ln w="38160">
              <a:solidFill>
                <a:srgbClr val="9900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"/>
            <p:cNvSpPr/>
            <p:nvPr/>
          </p:nvSpPr>
          <p:spPr>
            <a:xfrm>
              <a:off x="4248000" y="2973240"/>
              <a:ext cx="349560" cy="0"/>
            </a:xfrm>
            <a:prstGeom prst="line">
              <a:avLst/>
            </a:prstGeom>
            <a:ln w="38160">
              <a:solidFill>
                <a:srgbClr val="9900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"/>
            <p:cNvSpPr/>
            <p:nvPr/>
          </p:nvSpPr>
          <p:spPr>
            <a:xfrm>
              <a:off x="3986280" y="2973240"/>
              <a:ext cx="245880" cy="0"/>
            </a:xfrm>
            <a:prstGeom prst="line">
              <a:avLst/>
            </a:prstGeom>
            <a:ln w="38160">
              <a:solidFill>
                <a:srgbClr val="2d8f4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"/>
            <p:cNvSpPr/>
            <p:nvPr/>
          </p:nvSpPr>
          <p:spPr>
            <a:xfrm>
              <a:off x="4232520" y="274320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990099"/>
                  </a:solidFill>
                  <a:latin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4" name=""/>
          <p:cNvSpPr/>
          <p:nvPr/>
        </p:nvSpPr>
        <p:spPr>
          <a:xfrm>
            <a:off x="2413440" y="73342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c7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"/>
          <p:cNvSpPr/>
          <p:nvPr/>
        </p:nvSpPr>
        <p:spPr>
          <a:xfrm>
            <a:off x="2696040" y="73389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"/>
          <p:cNvSpPr/>
          <p:nvPr/>
        </p:nvSpPr>
        <p:spPr>
          <a:xfrm>
            <a:off x="3505680" y="73328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c7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"/>
          <p:cNvSpPr/>
          <p:nvPr/>
        </p:nvSpPr>
        <p:spPr>
          <a:xfrm>
            <a:off x="2373480" y="3225960"/>
            <a:ext cx="21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1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"/>
          <p:cNvSpPr/>
          <p:nvPr/>
        </p:nvSpPr>
        <p:spPr>
          <a:xfrm>
            <a:off x="2362320" y="7824960"/>
            <a:ext cx="21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685800" y="160200"/>
            <a:ext cx="5410080" cy="2065320"/>
          </a:xfrm>
          <a:prstGeom prst="rect">
            <a:avLst/>
          </a:prstGeom>
          <a:ln w="0">
            <a:noFill/>
          </a:ln>
        </p:spPr>
      </p:pic>
      <p:pic>
        <p:nvPicPr>
          <p:cNvPr id="103" name="" descr=""/>
          <p:cNvPicPr/>
          <p:nvPr/>
        </p:nvPicPr>
        <p:blipFill>
          <a:blip r:embed="rId2"/>
          <a:stretch/>
        </p:blipFill>
        <p:spPr>
          <a:xfrm>
            <a:off x="762120" y="2286000"/>
            <a:ext cx="5333760" cy="2033640"/>
          </a:xfrm>
          <a:prstGeom prst="rect">
            <a:avLst/>
          </a:prstGeom>
          <a:ln w="0">
            <a:noFill/>
          </a:ln>
        </p:spPr>
      </p:pic>
      <p:pic>
        <p:nvPicPr>
          <p:cNvPr id="104" name="" descr=""/>
          <p:cNvPicPr/>
          <p:nvPr/>
        </p:nvPicPr>
        <p:blipFill>
          <a:blip r:embed="rId3"/>
          <a:stretch/>
        </p:blipFill>
        <p:spPr>
          <a:xfrm>
            <a:off x="685800" y="6248520"/>
            <a:ext cx="5486400" cy="2082600"/>
          </a:xfrm>
          <a:prstGeom prst="rect">
            <a:avLst/>
          </a:prstGeom>
          <a:ln w="0">
            <a:noFill/>
          </a:ln>
        </p:spPr>
      </p:pic>
      <p:pic>
        <p:nvPicPr>
          <p:cNvPr id="105" name="" descr=""/>
          <p:cNvPicPr/>
          <p:nvPr/>
        </p:nvPicPr>
        <p:blipFill>
          <a:blip r:embed="rId4"/>
          <a:stretch/>
        </p:blipFill>
        <p:spPr>
          <a:xfrm>
            <a:off x="685800" y="4379760"/>
            <a:ext cx="5486400" cy="1855800"/>
          </a:xfrm>
          <a:prstGeom prst="rect">
            <a:avLst/>
          </a:prstGeom>
          <a:ln w="0">
            <a:noFill/>
          </a:ln>
        </p:spPr>
      </p:pic>
      <p:sp>
        <p:nvSpPr>
          <p:cNvPr id="106" name=""/>
          <p:cNvSpPr/>
          <p:nvPr/>
        </p:nvSpPr>
        <p:spPr>
          <a:xfrm>
            <a:off x="939960" y="1930320"/>
            <a:ext cx="91260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878120" y="1930320"/>
            <a:ext cx="129528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H="1" rot="10800000">
            <a:off x="1828800" y="195588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33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930320" y="4033800"/>
            <a:ext cx="129564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243240" y="4033800"/>
            <a:ext cx="723960" cy="0"/>
          </a:xfrm>
          <a:prstGeom prst="line">
            <a:avLst/>
          </a:prstGeom>
          <a:ln w="38160">
            <a:solidFill>
              <a:srgbClr val="dc891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H="1" rot="10800000">
            <a:off x="3197880" y="4051080"/>
            <a:ext cx="75960" cy="16956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33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259080" y="5892840"/>
            <a:ext cx="723960" cy="0"/>
          </a:xfrm>
          <a:prstGeom prst="line">
            <a:avLst/>
          </a:prstGeom>
          <a:ln w="38160">
            <a:solidFill>
              <a:srgbClr val="dc891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997440" y="5892840"/>
            <a:ext cx="34272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flipH="1" rot="10800000">
            <a:off x="3950280" y="5918040"/>
            <a:ext cx="7596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33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038480" y="7921800"/>
            <a:ext cx="30816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4356000" y="7920000"/>
            <a:ext cx="1435320" cy="0"/>
          </a:xfrm>
          <a:prstGeom prst="line">
            <a:avLst/>
          </a:prstGeom>
          <a:ln w="381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flipH="1" rot="10800000">
            <a:off x="4309920" y="795024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33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203840" y="18842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9999"/>
                </a:solidFill>
                <a:latin typeface="Arial"/>
              </a:rPr>
              <a:t>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314800" y="18892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00cc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314800" y="40006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00cc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429360" y="40006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dc891a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476880" y="5846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dc891a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991320" y="5845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015080" y="7878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4905720" y="7878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cc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703160" y="96840"/>
            <a:ext cx="34009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2 – difference NLE19-NLE14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773000" y="2206800"/>
            <a:ext cx="33307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2 – difference NLE14-NLE20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753920" y="4314960"/>
            <a:ext cx="33307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2 – difference NLE20-NLE17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753920" y="6222960"/>
            <a:ext cx="33307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2 – difference NLE17-NLE22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391040" y="82630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9999"/>
                </a:solidFill>
                <a:latin typeface="Arial"/>
              </a:rPr>
              <a:t>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591280" y="82630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00cc"/>
                </a:solidFill>
                <a:latin typeface="Arial"/>
              </a:rPr>
              <a:t>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681720" y="82630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dc891a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118400" y="82551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829400" y="82612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cc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5" name=""/>
          <p:cNvGrpSpPr/>
          <p:nvPr/>
        </p:nvGrpSpPr>
        <p:grpSpPr>
          <a:xfrm>
            <a:off x="1160640" y="8607960"/>
            <a:ext cx="4555080" cy="193320"/>
            <a:chOff x="1160640" y="8607960"/>
            <a:chExt cx="4555080" cy="193320"/>
          </a:xfrm>
        </p:grpSpPr>
        <p:sp>
          <p:nvSpPr>
            <p:cNvPr id="136" name=""/>
            <p:cNvSpPr/>
            <p:nvPr/>
          </p:nvSpPr>
          <p:spPr>
            <a:xfrm rot="16200000">
              <a:off x="2057400" y="7712280"/>
              <a:ext cx="187560" cy="198144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08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rot="16200000">
              <a:off x="4378320" y="7462440"/>
              <a:ext cx="188640" cy="248616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08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rot="16200000">
              <a:off x="1269720" y="8638920"/>
              <a:ext cx="189000" cy="1270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rot="16200000">
              <a:off x="1603800" y="8620560"/>
              <a:ext cx="189000" cy="16380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rot="16200000">
              <a:off x="2028600" y="8558640"/>
              <a:ext cx="187560" cy="2890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rot="16200000">
              <a:off x="2335320" y="8641800"/>
              <a:ext cx="188640" cy="1270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rot="16200000">
              <a:off x="2709000" y="8620200"/>
              <a:ext cx="189000" cy="1645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rot="16200000">
              <a:off x="3317040" y="8643240"/>
              <a:ext cx="188640" cy="1270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rot="16200000">
              <a:off x="3508200" y="8663040"/>
              <a:ext cx="188640" cy="874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0680" bIns="406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rot="16200000">
              <a:off x="3652920" y="8663040"/>
              <a:ext cx="188640" cy="874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0680" bIns="406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rot="16200000">
              <a:off x="3967920" y="8620920"/>
              <a:ext cx="187560" cy="1645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rot="16200000">
              <a:off x="4262400" y="8599680"/>
              <a:ext cx="188640" cy="2145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rot="16200000">
              <a:off x="4638600" y="8624520"/>
              <a:ext cx="188640" cy="1645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rot="16200000">
              <a:off x="4817160" y="8643600"/>
              <a:ext cx="188640" cy="1267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rot="16200000">
              <a:off x="5146560" y="8639640"/>
              <a:ext cx="187560" cy="1270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rot="16200000">
              <a:off x="5409360" y="8639640"/>
              <a:ext cx="187560" cy="1270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08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rot="16200000">
              <a:off x="3120840" y="8670960"/>
              <a:ext cx="136440" cy="7632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3" name=""/>
          <p:cNvSpPr/>
          <p:nvPr/>
        </p:nvSpPr>
        <p:spPr>
          <a:xfrm>
            <a:off x="1152360" y="8518680"/>
            <a:ext cx="876600" cy="0"/>
          </a:xfrm>
          <a:prstGeom prst="line">
            <a:avLst/>
          </a:prstGeom>
          <a:ln w="381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041560" y="8518680"/>
            <a:ext cx="1514520" cy="0"/>
          </a:xfrm>
          <a:prstGeom prst="line">
            <a:avLst/>
          </a:prstGeom>
          <a:ln w="38160">
            <a:solidFill>
              <a:srgbClr val="f046d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3564000" y="8518680"/>
            <a:ext cx="617400" cy="0"/>
          </a:xfrm>
          <a:prstGeom prst="line">
            <a:avLst/>
          </a:prstGeom>
          <a:ln w="38160">
            <a:solidFill>
              <a:srgbClr val="dc891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189320" y="8518680"/>
            <a:ext cx="25236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4449600" y="8518680"/>
            <a:ext cx="1274760" cy="0"/>
          </a:xfrm>
          <a:prstGeom prst="line">
            <a:avLst/>
          </a:prstGeom>
          <a:ln w="381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424600" y="8827920"/>
            <a:ext cx="20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9" name="" descr=""/>
          <p:cNvPicPr/>
          <p:nvPr/>
        </p:nvPicPr>
        <p:blipFill>
          <a:blip r:embed="rId1"/>
          <a:stretch/>
        </p:blipFill>
        <p:spPr>
          <a:xfrm>
            <a:off x="609480" y="152280"/>
            <a:ext cx="5604120" cy="2057400"/>
          </a:xfrm>
          <a:prstGeom prst="rect">
            <a:avLst/>
          </a:prstGeom>
          <a:ln w="0">
            <a:noFill/>
          </a:ln>
        </p:spPr>
      </p:pic>
      <p:pic>
        <p:nvPicPr>
          <p:cNvPr id="160" name="" descr=""/>
          <p:cNvPicPr/>
          <p:nvPr/>
        </p:nvPicPr>
        <p:blipFill>
          <a:blip r:embed="rId2"/>
          <a:stretch/>
        </p:blipFill>
        <p:spPr>
          <a:xfrm>
            <a:off x="627120" y="2286000"/>
            <a:ext cx="5545080" cy="1905120"/>
          </a:xfrm>
          <a:prstGeom prst="rect">
            <a:avLst/>
          </a:prstGeom>
          <a:ln w="0">
            <a:noFill/>
          </a:ln>
        </p:spPr>
      </p:pic>
      <p:pic>
        <p:nvPicPr>
          <p:cNvPr id="161" name="" descr=""/>
          <p:cNvPicPr/>
          <p:nvPr/>
        </p:nvPicPr>
        <p:blipFill>
          <a:blip r:embed="rId3"/>
          <a:stretch/>
        </p:blipFill>
        <p:spPr>
          <a:xfrm>
            <a:off x="627120" y="4191120"/>
            <a:ext cx="5570640" cy="2133360"/>
          </a:xfrm>
          <a:prstGeom prst="rect">
            <a:avLst/>
          </a:prstGeom>
          <a:ln w="0">
            <a:noFill/>
          </a:ln>
        </p:spPr>
      </p:pic>
      <p:pic>
        <p:nvPicPr>
          <p:cNvPr id="162" name="" descr=""/>
          <p:cNvPicPr/>
          <p:nvPr/>
        </p:nvPicPr>
        <p:blipFill>
          <a:blip r:embed="rId4"/>
          <a:stretch/>
        </p:blipFill>
        <p:spPr>
          <a:xfrm>
            <a:off x="609480" y="6324480"/>
            <a:ext cx="5562720" cy="1905120"/>
          </a:xfrm>
          <a:prstGeom prst="rect">
            <a:avLst/>
          </a:prstGeom>
          <a:ln w="0">
            <a:noFill/>
          </a:ln>
        </p:spPr>
      </p:pic>
      <p:sp>
        <p:nvSpPr>
          <p:cNvPr id="163" name=""/>
          <p:cNvSpPr/>
          <p:nvPr/>
        </p:nvSpPr>
        <p:spPr>
          <a:xfrm>
            <a:off x="866880" y="1843200"/>
            <a:ext cx="352440" cy="0"/>
          </a:xfrm>
          <a:prstGeom prst="line">
            <a:avLst/>
          </a:prstGeom>
          <a:ln w="3816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209680" y="1843200"/>
            <a:ext cx="1981440" cy="0"/>
          </a:xfrm>
          <a:prstGeom prst="line">
            <a:avLst/>
          </a:prstGeom>
          <a:ln w="3816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238400" y="1843200"/>
            <a:ext cx="22860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4210200" y="1843200"/>
            <a:ext cx="43812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H="1" rot="10800000">
            <a:off x="1190520" y="1881000"/>
            <a:ext cx="76320" cy="169560"/>
          </a:xfrm>
          <a:prstGeom prst="flowChartMerge">
            <a:avLst/>
          </a:prstGeom>
          <a:solidFill>
            <a:srgbClr val="ff00ff"/>
          </a:solidFill>
          <a:ln w="9360">
            <a:solidFill>
              <a:srgbClr val="cc00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flipH="1" rot="10800000">
            <a:off x="4162320" y="1863720"/>
            <a:ext cx="76320" cy="169920"/>
          </a:xfrm>
          <a:prstGeom prst="flowChartMerge">
            <a:avLst/>
          </a:prstGeom>
          <a:solidFill>
            <a:srgbClr val="ff00ff"/>
          </a:solidFill>
          <a:ln w="9360">
            <a:solidFill>
              <a:srgbClr val="cc00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1219320" y="3944880"/>
            <a:ext cx="15228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390680" y="3944880"/>
            <a:ext cx="895320" cy="0"/>
          </a:xfrm>
          <a:prstGeom prst="line">
            <a:avLst/>
          </a:prstGeom>
          <a:ln w="381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flipH="1" rot="10800000">
            <a:off x="1342080" y="3983040"/>
            <a:ext cx="75960" cy="169920"/>
          </a:xfrm>
          <a:prstGeom prst="flowChartMerge">
            <a:avLst/>
          </a:prstGeom>
          <a:solidFill>
            <a:srgbClr val="ff00ff"/>
          </a:solidFill>
          <a:ln w="9360">
            <a:solidFill>
              <a:srgbClr val="cc00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1338120" y="6019920"/>
            <a:ext cx="990720" cy="0"/>
          </a:xfrm>
          <a:prstGeom prst="line">
            <a:avLst/>
          </a:prstGeom>
          <a:ln w="381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338560" y="6019920"/>
            <a:ext cx="1981080" cy="0"/>
          </a:xfrm>
          <a:prstGeom prst="line">
            <a:avLst/>
          </a:prstGeom>
          <a:ln w="3816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 flipH="1" rot="10800000">
            <a:off x="2295360" y="6048360"/>
            <a:ext cx="76320" cy="169920"/>
          </a:xfrm>
          <a:prstGeom prst="flowChartMerge">
            <a:avLst/>
          </a:prstGeom>
          <a:solidFill>
            <a:srgbClr val="ff00ff"/>
          </a:solidFill>
          <a:ln w="9360">
            <a:solidFill>
              <a:srgbClr val="cc00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4195800" y="7956720"/>
            <a:ext cx="43812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4648320" y="7956720"/>
            <a:ext cx="137160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H="1" rot="10800000">
            <a:off x="4600440" y="7980480"/>
            <a:ext cx="76320" cy="169920"/>
          </a:xfrm>
          <a:prstGeom prst="flowChartMerge">
            <a:avLst/>
          </a:prstGeom>
          <a:solidFill>
            <a:srgbClr val="ff00ff"/>
          </a:solidFill>
          <a:ln w="9360">
            <a:solidFill>
              <a:srgbClr val="cc00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851400" y="18208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00"/>
                </a:solidFill>
                <a:latin typeface="Arial"/>
              </a:rPr>
              <a:t>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3124440" y="18208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00"/>
                </a:solidFill>
                <a:latin typeface="Arial"/>
              </a:rPr>
              <a:t>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3076920" y="59673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00"/>
                </a:solidFill>
                <a:latin typeface="Arial"/>
              </a:rPr>
              <a:t>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4304880" y="18208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1142640" y="3895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1713960" y="38908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200a7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1739520" y="59659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200a7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4314240" y="79056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5085000" y="7899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1859040" y="60480"/>
            <a:ext cx="30855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3 – difference NLE21-NLE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1886400" y="2193840"/>
            <a:ext cx="30153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3 – difference NLE4-NLE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1856160" y="4149720"/>
            <a:ext cx="30855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3 – difference NLE4-NLE2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865520" y="6286680"/>
            <a:ext cx="30855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3 – difference NLE11-NLE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1233000" y="1833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2" name=""/>
          <p:cNvGrpSpPr/>
          <p:nvPr/>
        </p:nvGrpSpPr>
        <p:grpSpPr>
          <a:xfrm>
            <a:off x="1397520" y="8166240"/>
            <a:ext cx="4022280" cy="515880"/>
            <a:chOff x="1397520" y="8166240"/>
            <a:chExt cx="4022280" cy="515880"/>
          </a:xfrm>
        </p:grpSpPr>
        <p:grpSp>
          <p:nvGrpSpPr>
            <p:cNvPr id="193" name=""/>
            <p:cNvGrpSpPr/>
            <p:nvPr/>
          </p:nvGrpSpPr>
          <p:grpSpPr>
            <a:xfrm>
              <a:off x="1486080" y="8474040"/>
              <a:ext cx="3916080" cy="208080"/>
              <a:chOff x="1486080" y="8474040"/>
              <a:chExt cx="3916080" cy="208080"/>
            </a:xfrm>
          </p:grpSpPr>
          <p:sp>
            <p:nvSpPr>
              <p:cNvPr id="194" name=""/>
              <p:cNvSpPr/>
              <p:nvPr/>
            </p:nvSpPr>
            <p:spPr>
              <a:xfrm rot="16200000">
                <a:off x="2223360" y="7744680"/>
                <a:ext cx="201600" cy="1673280"/>
              </a:xfrm>
              <a:prstGeom prst="rect">
                <a:avLst/>
              </a:prstGeom>
              <a:gradFill rotWithShape="0">
                <a:gsLst>
                  <a:gs pos="0">
                    <a:srgbClr val="d9e7fb"/>
                  </a:gs>
                  <a:gs pos="50000">
                    <a:srgbClr val="ffffff"/>
                  </a:gs>
                  <a:gs pos="100000">
                    <a:srgbClr val="d9e7fb"/>
                  </a:gs>
                </a:gsLst>
                <a:lin ang="16200000"/>
              </a:gradFill>
              <a:ln w="9360">
                <a:solidFill>
                  <a:srgbClr val="71bfc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 rot="16200000">
                <a:off x="1465200" y="8501400"/>
                <a:ext cx="200160" cy="15840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 rot="16200000">
                <a:off x="1751400" y="8470080"/>
                <a:ext cx="200160" cy="22068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 rot="16200000">
                <a:off x="2011320" y="8511840"/>
                <a:ext cx="199800" cy="12384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rot="16200000">
                <a:off x="2607480" y="8463600"/>
                <a:ext cx="199800" cy="22068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 rot="16200000">
                <a:off x="2946960" y="8452440"/>
                <a:ext cx="201600" cy="25740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 rot="16200000">
                <a:off x="4281480" y="7553160"/>
                <a:ext cx="199800" cy="2041560"/>
              </a:xfrm>
              <a:prstGeom prst="rect">
                <a:avLst/>
              </a:prstGeom>
              <a:gradFill rotWithShape="0">
                <a:gsLst>
                  <a:gs pos="0">
                    <a:srgbClr val="d9e7fb"/>
                  </a:gs>
                  <a:gs pos="50000">
                    <a:srgbClr val="ffffff"/>
                  </a:gs>
                  <a:gs pos="100000">
                    <a:srgbClr val="d9e7fb"/>
                  </a:gs>
                </a:gsLst>
                <a:lin ang="16200000"/>
              </a:gradFill>
              <a:ln w="9360">
                <a:solidFill>
                  <a:srgbClr val="71bfc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 flipV="1" rot="16200000">
                <a:off x="3220920" y="8510040"/>
                <a:ext cx="199800" cy="1270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b2b2b2"/>
                  </a:gs>
                  <a:gs pos="100000">
                    <a:srgbClr val="000000"/>
                  </a:gs>
                </a:gsLst>
                <a:lin ang="5400000"/>
              </a:gra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 rot="16200000">
                <a:off x="3387600" y="8511840"/>
                <a:ext cx="199800" cy="12384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 rot="16200000">
                <a:off x="3579120" y="8482680"/>
                <a:ext cx="199800" cy="18252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rot="16200000">
                <a:off x="3885480" y="8524080"/>
                <a:ext cx="198360" cy="9828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 rot="16200000">
                <a:off x="4114080" y="8482680"/>
                <a:ext cx="199800" cy="18252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rot="16200000">
                <a:off x="4442040" y="8494560"/>
                <a:ext cx="199800" cy="15876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 rot="16200000">
                <a:off x="4645080" y="8494560"/>
                <a:ext cx="199800" cy="15876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 rot="16200000">
                <a:off x="4906800" y="8511840"/>
                <a:ext cx="199800" cy="12384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 rot="16200000">
                <a:off x="3143160" y="8550360"/>
                <a:ext cx="144720" cy="74880"/>
              </a:xfrm>
              <a:prstGeom prst="rect">
                <a:avLst/>
              </a:prstGeom>
              <a:blipFill rotWithShape="0">
                <a:blip r:embed="rId5"/>
                <a:srcRect/>
                <a:tile tx="0" ty="0" sx="100000" sy="100000" algn="ctr"/>
              </a:blip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8080" bIns="280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0" name=""/>
            <p:cNvSpPr/>
            <p:nvPr/>
          </p:nvSpPr>
          <p:spPr>
            <a:xfrm>
              <a:off x="1474920" y="8404560"/>
              <a:ext cx="195120" cy="0"/>
            </a:xfrm>
            <a:prstGeom prst="line">
              <a:avLst/>
            </a:prstGeom>
            <a:ln w="38160">
              <a:solidFill>
                <a:srgbClr val="ff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1677960" y="8404560"/>
              <a:ext cx="195120" cy="0"/>
            </a:xfrm>
            <a:prstGeom prst="line">
              <a:avLst/>
            </a:prstGeom>
            <a:ln w="38160">
              <a:solidFill>
                <a:srgbClr val="57d2e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1886040" y="8404560"/>
              <a:ext cx="819000" cy="0"/>
            </a:xfrm>
            <a:prstGeom prst="line">
              <a:avLst/>
            </a:prstGeom>
            <a:ln w="38160">
              <a:solidFill>
                <a:srgbClr val="f200a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2716200" y="8404560"/>
              <a:ext cx="1222560" cy="0"/>
            </a:xfrm>
            <a:prstGeom prst="line">
              <a:avLst/>
            </a:prstGeom>
            <a:ln w="38160">
              <a:solidFill>
                <a:srgbClr val="ff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3957480" y="8404560"/>
              <a:ext cx="328680" cy="0"/>
            </a:xfrm>
            <a:prstGeom prst="line">
              <a:avLst/>
            </a:prstGeom>
            <a:ln w="38160">
              <a:solidFill>
                <a:srgbClr val="57d2e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4295880" y="8404560"/>
              <a:ext cx="1123920" cy="0"/>
            </a:xfrm>
            <a:prstGeom prst="line">
              <a:avLst/>
            </a:prstGeom>
            <a:ln w="38160">
              <a:solidFill>
                <a:srgbClr val="9966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1637640" y="817272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57d2ef"/>
                  </a:solidFill>
                  <a:latin typeface="Arial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1397520" y="817272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9900"/>
                  </a:solidFill>
                  <a:latin typeface="Arial"/>
                </a:rPr>
                <a:t>2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3076920" y="817272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9900"/>
                  </a:solidFill>
                  <a:latin typeface="Arial"/>
                </a:rPr>
                <a:t>2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3970440" y="8180640"/>
              <a:ext cx="268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57d2ef"/>
                  </a:solidFill>
                  <a:latin typeface="Arial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2183760" y="816624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200a7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509000" y="817092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996633"/>
                  </a:solidFill>
                  <a:latin typeface="Arial"/>
                </a:rPr>
                <a:t>1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2" name=""/>
          <p:cNvSpPr/>
          <p:nvPr/>
        </p:nvSpPr>
        <p:spPr>
          <a:xfrm>
            <a:off x="2321280" y="8637480"/>
            <a:ext cx="20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3" name="" descr=""/>
          <p:cNvPicPr/>
          <p:nvPr/>
        </p:nvPicPr>
        <p:blipFill>
          <a:blip r:embed="rId1"/>
          <a:stretch/>
        </p:blipFill>
        <p:spPr>
          <a:xfrm>
            <a:off x="380880" y="127080"/>
            <a:ext cx="5943600" cy="2662200"/>
          </a:xfrm>
          <a:prstGeom prst="rect">
            <a:avLst/>
          </a:prstGeom>
          <a:ln w="0">
            <a:noFill/>
          </a:ln>
        </p:spPr>
      </p:pic>
      <p:pic>
        <p:nvPicPr>
          <p:cNvPr id="224" name="" descr=""/>
          <p:cNvPicPr/>
          <p:nvPr/>
        </p:nvPicPr>
        <p:blipFill>
          <a:blip r:embed="rId2"/>
          <a:stretch/>
        </p:blipFill>
        <p:spPr>
          <a:xfrm>
            <a:off x="507960" y="2832120"/>
            <a:ext cx="5816520" cy="2708280"/>
          </a:xfrm>
          <a:prstGeom prst="rect">
            <a:avLst/>
          </a:prstGeom>
          <a:ln w="0">
            <a:noFill/>
          </a:ln>
        </p:spPr>
      </p:pic>
      <p:pic>
        <p:nvPicPr>
          <p:cNvPr id="225" name="" descr=""/>
          <p:cNvPicPr/>
          <p:nvPr/>
        </p:nvPicPr>
        <p:blipFill>
          <a:blip r:embed="rId3"/>
          <a:stretch/>
        </p:blipFill>
        <p:spPr>
          <a:xfrm>
            <a:off x="533520" y="5562720"/>
            <a:ext cx="5867280" cy="2666880"/>
          </a:xfrm>
          <a:prstGeom prst="rect">
            <a:avLst/>
          </a:prstGeom>
          <a:ln w="0">
            <a:noFill/>
          </a:ln>
        </p:spPr>
      </p:pic>
      <p:sp>
        <p:nvSpPr>
          <p:cNvPr id="226" name=""/>
          <p:cNvSpPr/>
          <p:nvPr/>
        </p:nvSpPr>
        <p:spPr>
          <a:xfrm>
            <a:off x="1802160" y="57240"/>
            <a:ext cx="30855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4 – difference NLE20-NLE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1738080" y="2793960"/>
            <a:ext cx="33660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4 – difference NLE9-NLE18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1817640" y="5562720"/>
            <a:ext cx="33307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4 – difference NLE18-NLE7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685800" y="2438280"/>
            <a:ext cx="1371600" cy="0"/>
          </a:xfrm>
          <a:prstGeom prst="line">
            <a:avLst/>
          </a:prstGeom>
          <a:ln w="38160">
            <a:solidFill>
              <a:srgbClr val="dc891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146320" y="2428920"/>
            <a:ext cx="1663560" cy="0"/>
          </a:xfrm>
          <a:prstGeom prst="line">
            <a:avLst/>
          </a:prstGeom>
          <a:ln w="381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flipH="1" rot="10800000">
            <a:off x="2070000" y="2467080"/>
            <a:ext cx="76320" cy="169920"/>
          </a:xfrm>
          <a:prstGeom prst="flowChartMerge">
            <a:avLst/>
          </a:prstGeom>
          <a:solidFill>
            <a:srgbClr val="57d2ef"/>
          </a:solidFill>
          <a:ln w="93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2236680" y="5205240"/>
            <a:ext cx="1549440" cy="0"/>
          </a:xfrm>
          <a:prstGeom prst="line">
            <a:avLst/>
          </a:prstGeom>
          <a:ln w="381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3807000" y="5207040"/>
            <a:ext cx="27432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 flipH="1" rot="10800000">
            <a:off x="3754440" y="5232240"/>
            <a:ext cx="76320" cy="169920"/>
          </a:xfrm>
          <a:prstGeom prst="flowChartMerge">
            <a:avLst/>
          </a:prstGeom>
          <a:solidFill>
            <a:srgbClr val="333399"/>
          </a:solidFill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3854520" y="7848720"/>
            <a:ext cx="27468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4148280" y="7848720"/>
            <a:ext cx="2023920" cy="0"/>
          </a:xfrm>
          <a:prstGeom prst="line">
            <a:avLst/>
          </a:prstGeom>
          <a:ln w="3816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 flipH="1" rot="10800000">
            <a:off x="4103640" y="7881840"/>
            <a:ext cx="76320" cy="169920"/>
          </a:xfrm>
          <a:prstGeom prst="flowChartMerge">
            <a:avLst/>
          </a:prstGeom>
          <a:solidFill>
            <a:srgbClr val="333399"/>
          </a:solidFill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1140120" y="2400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dc891a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2552040" y="23893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cc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2937960" y="5148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cc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759480" y="51530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3797640" y="78008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4953960" y="77961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99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1872000" y="82630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dc891a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2972880" y="82659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cc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3538800" y="82645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4344480" y="82659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99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 rot="16200000">
            <a:off x="1950120" y="8239320"/>
            <a:ext cx="190440" cy="881280"/>
          </a:xfrm>
          <a:prstGeom prst="rect">
            <a:avLst/>
          </a:prstGeom>
          <a:gradFill rotWithShape="0">
            <a:gsLst>
              <a:gs pos="0">
                <a:srgbClr val="d9e7fb"/>
              </a:gs>
              <a:gs pos="50000">
                <a:srgbClr val="ffffff"/>
              </a:gs>
              <a:gs pos="100000">
                <a:srgbClr val="d9e7fb"/>
              </a:gs>
            </a:gsLst>
            <a:lin ang="16200000"/>
          </a:gradFill>
          <a:ln w="93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 rot="16200000">
            <a:off x="3809880" y="7358040"/>
            <a:ext cx="190800" cy="2641680"/>
          </a:xfrm>
          <a:prstGeom prst="rect">
            <a:avLst/>
          </a:prstGeom>
          <a:gradFill rotWithShape="0">
            <a:gsLst>
              <a:gs pos="0">
                <a:srgbClr val="d9e7fb"/>
              </a:gs>
              <a:gs pos="50000">
                <a:srgbClr val="ffffff"/>
              </a:gs>
              <a:gs pos="100000">
                <a:srgbClr val="d9e7fb"/>
              </a:gs>
            </a:gsLst>
            <a:lin ang="16200000"/>
          </a:gradFill>
          <a:ln w="93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rot="16200000">
            <a:off x="1801800" y="8597520"/>
            <a:ext cx="190440" cy="16524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 rot="16200000">
            <a:off x="1992240" y="8613360"/>
            <a:ext cx="190440" cy="12708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 rot="16200000">
            <a:off x="2241360" y="8629200"/>
            <a:ext cx="190440" cy="10152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rot="16200000">
            <a:off x="2715840" y="8564400"/>
            <a:ext cx="190800" cy="22860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 rot="16200000">
            <a:off x="3190680" y="8596440"/>
            <a:ext cx="190800" cy="16488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 rot="16200000">
            <a:off x="3400920" y="8596800"/>
            <a:ext cx="190800" cy="16380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 rot="16200000">
            <a:off x="3686760" y="8565480"/>
            <a:ext cx="190800" cy="22680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 rot="16200000">
            <a:off x="4019400" y="8564400"/>
            <a:ext cx="190800" cy="22860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 rot="16200000">
            <a:off x="4331160" y="8628840"/>
            <a:ext cx="190800" cy="9972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 rot="16200000">
            <a:off x="4604400" y="8565480"/>
            <a:ext cx="190800" cy="22680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 rot="16200000">
            <a:off x="4878000" y="8615160"/>
            <a:ext cx="190800" cy="12708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 rot="16200000">
            <a:off x="2466000" y="8642520"/>
            <a:ext cx="137880" cy="7632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 flipV="1">
            <a:off x="1600200" y="8493120"/>
            <a:ext cx="893880" cy="1440"/>
          </a:xfrm>
          <a:prstGeom prst="line">
            <a:avLst/>
          </a:prstGeom>
          <a:ln w="38160">
            <a:solidFill>
              <a:srgbClr val="dc891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 flipV="1">
            <a:off x="2563920" y="8493120"/>
            <a:ext cx="1017360" cy="1440"/>
          </a:xfrm>
          <a:prstGeom prst="line">
            <a:avLst/>
          </a:prstGeom>
          <a:ln w="381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 flipV="1">
            <a:off x="3608280" y="8493120"/>
            <a:ext cx="238320" cy="144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 flipV="1">
            <a:off x="3870360" y="8493120"/>
            <a:ext cx="1373040" cy="1440"/>
          </a:xfrm>
          <a:prstGeom prst="line">
            <a:avLst/>
          </a:prstGeom>
          <a:ln w="3816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2397600" y="8737560"/>
            <a:ext cx="20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7" name="" descr=""/>
          <p:cNvPicPr/>
          <p:nvPr/>
        </p:nvPicPr>
        <p:blipFill>
          <a:blip r:embed="rId1"/>
          <a:stretch/>
        </p:blipFill>
        <p:spPr>
          <a:xfrm>
            <a:off x="380880" y="351000"/>
            <a:ext cx="6172200" cy="3078000"/>
          </a:xfrm>
          <a:prstGeom prst="rect">
            <a:avLst/>
          </a:prstGeom>
          <a:ln w="0">
            <a:noFill/>
          </a:ln>
        </p:spPr>
      </p:pic>
      <p:pic>
        <p:nvPicPr>
          <p:cNvPr id="268" name="" descr=""/>
          <p:cNvPicPr/>
          <p:nvPr/>
        </p:nvPicPr>
        <p:blipFill>
          <a:blip r:embed="rId2"/>
          <a:stretch/>
        </p:blipFill>
        <p:spPr>
          <a:xfrm>
            <a:off x="457200" y="3886200"/>
            <a:ext cx="6095880" cy="2971800"/>
          </a:xfrm>
          <a:prstGeom prst="rect">
            <a:avLst/>
          </a:prstGeom>
          <a:ln w="0">
            <a:noFill/>
          </a:ln>
        </p:spPr>
      </p:pic>
      <p:sp>
        <p:nvSpPr>
          <p:cNvPr id="269" name=""/>
          <p:cNvSpPr/>
          <p:nvPr/>
        </p:nvSpPr>
        <p:spPr>
          <a:xfrm>
            <a:off x="1716120" y="368280"/>
            <a:ext cx="34923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5 – difference NLE6&amp;7-NLE18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1830240" y="3949560"/>
            <a:ext cx="33307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5 – difference NLE18-NLE2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623880" y="2967120"/>
            <a:ext cx="1644480" cy="0"/>
          </a:xfrm>
          <a:prstGeom prst="line">
            <a:avLst/>
          </a:prstGeom>
          <a:ln w="3816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2284560" y="2967120"/>
            <a:ext cx="67284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 flipH="1" rot="10800000">
            <a:off x="2237400" y="2995560"/>
            <a:ext cx="75960" cy="169920"/>
          </a:xfrm>
          <a:prstGeom prst="flowChartMerge">
            <a:avLst/>
          </a:prstGeom>
          <a:solidFill>
            <a:srgbClr val="f200a7"/>
          </a:solidFill>
          <a:ln w="93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2260440" y="6477120"/>
            <a:ext cx="67320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2959200" y="6477120"/>
            <a:ext cx="3200400" cy="0"/>
          </a:xfrm>
          <a:prstGeom prst="line">
            <a:avLst/>
          </a:prstGeom>
          <a:ln w="381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 flipH="1" rot="10800000">
            <a:off x="2907360" y="6502320"/>
            <a:ext cx="75960" cy="169920"/>
          </a:xfrm>
          <a:prstGeom prst="flowChartMerge">
            <a:avLst/>
          </a:prstGeom>
          <a:solidFill>
            <a:srgbClr val="f200a7"/>
          </a:solidFill>
          <a:ln w="93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2679840" y="1600200"/>
            <a:ext cx="152280" cy="76320"/>
          </a:xfrm>
          <a:prstGeom prst="rect">
            <a:avLst/>
          </a:prstGeom>
          <a:solidFill>
            <a:srgbClr val="35f735"/>
          </a:solidFill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4775040" y="825480"/>
            <a:ext cx="152640" cy="76320"/>
          </a:xfrm>
          <a:prstGeom prst="rect">
            <a:avLst/>
          </a:prstGeom>
          <a:solidFill>
            <a:srgbClr val="35f735"/>
          </a:solidFill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4879440" y="733320"/>
            <a:ext cx="153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egmental duplic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1270440" y="291924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99"/>
                </a:solidFill>
                <a:latin typeface="Arial"/>
              </a:rPr>
              <a:t>6&amp;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2514960" y="29257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2400840" y="64515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4220640" y="6451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33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2010240" y="718344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99"/>
                </a:solidFill>
                <a:latin typeface="Arial"/>
              </a:rPr>
              <a:t>6&amp;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2810160" y="71881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999960" y="7182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33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 rot="16200000">
            <a:off x="2046240" y="7133760"/>
            <a:ext cx="189000" cy="916200"/>
          </a:xfrm>
          <a:prstGeom prst="rect">
            <a:avLst/>
          </a:prstGeom>
          <a:gradFill rotWithShape="0">
            <a:gsLst>
              <a:gs pos="0">
                <a:srgbClr val="d9e7fb"/>
              </a:gs>
              <a:gs pos="50000">
                <a:srgbClr val="ffffff"/>
              </a:gs>
              <a:gs pos="100000">
                <a:srgbClr val="d9e7fb"/>
              </a:gs>
            </a:gsLst>
            <a:lin ang="16200000"/>
          </a:gradFill>
          <a:ln w="93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 rot="16200000">
            <a:off x="3867120" y="6311520"/>
            <a:ext cx="190440" cy="2552760"/>
          </a:xfrm>
          <a:prstGeom prst="rect">
            <a:avLst/>
          </a:prstGeom>
          <a:gradFill rotWithShape="0">
            <a:gsLst>
              <a:gs pos="0">
                <a:srgbClr val="d9e7fb"/>
              </a:gs>
              <a:gs pos="50000">
                <a:srgbClr val="ffffff"/>
              </a:gs>
              <a:gs pos="100000">
                <a:srgbClr val="d9e7fb"/>
              </a:gs>
            </a:gsLst>
            <a:lin ang="16200000"/>
          </a:gradFill>
          <a:ln w="9360">
            <a:solidFill>
              <a:srgbClr val="71bfc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 rot="16200000">
            <a:off x="1870200" y="7538760"/>
            <a:ext cx="190440" cy="10476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 rot="16200000">
            <a:off x="2108880" y="7472880"/>
            <a:ext cx="190440" cy="23652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 rot="16200000">
            <a:off x="2452680" y="7538760"/>
            <a:ext cx="190440" cy="10476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 rot="16200000">
            <a:off x="2856600" y="7521840"/>
            <a:ext cx="190440" cy="13176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 rot="16200000">
            <a:off x="3327480" y="7470360"/>
            <a:ext cx="190440" cy="23508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 rot="16200000">
            <a:off x="3645720" y="7469640"/>
            <a:ext cx="190440" cy="23652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 rot="16200000">
            <a:off x="3963960" y="7470360"/>
            <a:ext cx="190440" cy="23508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 rot="16200000">
            <a:off x="4511520" y="7521120"/>
            <a:ext cx="190440" cy="13320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 rot="16200000">
            <a:off x="4853160" y="7489440"/>
            <a:ext cx="190440" cy="196920"/>
          </a:xfrm>
          <a:prstGeom prst="rect">
            <a:avLst/>
          </a:prstGeom>
          <a:gradFill rotWithShape="0">
            <a:gsLst>
              <a:gs pos="0">
                <a:srgbClr val="666699"/>
              </a:gs>
              <a:gs pos="50000">
                <a:srgbClr val="e5f4ff"/>
              </a:gs>
              <a:gs pos="100000">
                <a:srgbClr val="666699"/>
              </a:gs>
            </a:gsLst>
            <a:lin ang="16200000"/>
          </a:grad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 rot="16200000">
            <a:off x="2575080" y="7551360"/>
            <a:ext cx="137880" cy="8100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4200" bIns="34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1695600" y="7416720"/>
            <a:ext cx="1100160" cy="0"/>
          </a:xfrm>
          <a:prstGeom prst="line">
            <a:avLst/>
          </a:prstGeom>
          <a:ln w="38160">
            <a:solidFill>
              <a:srgbClr val="0000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2808360" y="7416720"/>
            <a:ext cx="41904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3240000" y="7416720"/>
            <a:ext cx="2003400" cy="0"/>
          </a:xfrm>
          <a:prstGeom prst="line">
            <a:avLst/>
          </a:prstGeom>
          <a:ln w="381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397600" y="7672320"/>
            <a:ext cx="20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3" name="" descr=""/>
          <p:cNvPicPr/>
          <p:nvPr/>
        </p:nvPicPr>
        <p:blipFill>
          <a:blip r:embed="rId1"/>
          <a:stretch/>
        </p:blipFill>
        <p:spPr>
          <a:xfrm>
            <a:off x="457200" y="76320"/>
            <a:ext cx="5791320" cy="1981080"/>
          </a:xfrm>
          <a:prstGeom prst="rect">
            <a:avLst/>
          </a:prstGeom>
          <a:ln w="0">
            <a:noFill/>
          </a:ln>
        </p:spPr>
      </p:pic>
      <p:sp>
        <p:nvSpPr>
          <p:cNvPr id="304" name=""/>
          <p:cNvSpPr/>
          <p:nvPr/>
        </p:nvSpPr>
        <p:spPr>
          <a:xfrm>
            <a:off x="762120" y="1735200"/>
            <a:ext cx="76176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1547640" y="1735200"/>
            <a:ext cx="304920" cy="0"/>
          </a:xfrm>
          <a:prstGeom prst="line">
            <a:avLst/>
          </a:prstGeom>
          <a:ln w="381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2666880" y="1735200"/>
            <a:ext cx="408240" cy="0"/>
          </a:xfrm>
          <a:prstGeom prst="line">
            <a:avLst/>
          </a:prstGeom>
          <a:ln cap="rnd" w="38160">
            <a:solidFill>
              <a:srgbClr val="0066ff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3325680" y="1735200"/>
            <a:ext cx="2617920" cy="0"/>
          </a:xfrm>
          <a:prstGeom prst="line">
            <a:avLst/>
          </a:prstGeom>
          <a:ln cap="rnd" w="38160">
            <a:solidFill>
              <a:srgbClr val="0066ff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8" name="" descr=""/>
          <p:cNvPicPr/>
          <p:nvPr/>
        </p:nvPicPr>
        <p:blipFill>
          <a:blip r:embed="rId2"/>
          <a:stretch/>
        </p:blipFill>
        <p:spPr>
          <a:xfrm>
            <a:off x="533520" y="2184480"/>
            <a:ext cx="5715000" cy="1751040"/>
          </a:xfrm>
          <a:prstGeom prst="rect">
            <a:avLst/>
          </a:prstGeom>
          <a:ln w="0">
            <a:noFill/>
          </a:ln>
        </p:spPr>
      </p:pic>
      <p:sp>
        <p:nvSpPr>
          <p:cNvPr id="309" name=""/>
          <p:cNvSpPr/>
          <p:nvPr/>
        </p:nvSpPr>
        <p:spPr>
          <a:xfrm>
            <a:off x="1488960" y="3710160"/>
            <a:ext cx="306360" cy="0"/>
          </a:xfrm>
          <a:prstGeom prst="line">
            <a:avLst/>
          </a:prstGeom>
          <a:ln w="381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1814400" y="3710160"/>
            <a:ext cx="29556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112920" y="3710160"/>
            <a:ext cx="29376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3421080" y="3708360"/>
            <a:ext cx="2558880" cy="0"/>
          </a:xfrm>
          <a:prstGeom prst="line">
            <a:avLst/>
          </a:prstGeom>
          <a:ln w="381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2575080" y="3710160"/>
            <a:ext cx="525240" cy="0"/>
          </a:xfrm>
          <a:prstGeom prst="line">
            <a:avLst/>
          </a:prstGeom>
          <a:ln w="381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4" name="" descr=""/>
          <p:cNvPicPr/>
          <p:nvPr/>
        </p:nvPicPr>
        <p:blipFill>
          <a:blip r:embed="rId3"/>
          <a:stretch/>
        </p:blipFill>
        <p:spPr>
          <a:xfrm>
            <a:off x="457200" y="4114800"/>
            <a:ext cx="5791320" cy="1752480"/>
          </a:xfrm>
          <a:prstGeom prst="rect">
            <a:avLst/>
          </a:prstGeom>
          <a:ln w="0">
            <a:noFill/>
          </a:ln>
        </p:spPr>
      </p:pic>
      <p:sp>
        <p:nvSpPr>
          <p:cNvPr id="315" name=""/>
          <p:cNvSpPr/>
          <p:nvPr/>
        </p:nvSpPr>
        <p:spPr>
          <a:xfrm>
            <a:off x="1757520" y="5629320"/>
            <a:ext cx="26964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2046240" y="5629320"/>
            <a:ext cx="344520" cy="0"/>
          </a:xfrm>
          <a:prstGeom prst="line">
            <a:avLst/>
          </a:prstGeom>
          <a:ln w="381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1602000" y="60480"/>
            <a:ext cx="349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6 – difference NLE8-NLE1b&amp;3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1516320" y="2108160"/>
            <a:ext cx="376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6 – difference NLE1b&amp;3-NLE17&amp;18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1663920" y="4060800"/>
            <a:ext cx="338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6 – difference NLE17&amp;18-NLE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0" name="" descr=""/>
          <p:cNvPicPr/>
          <p:nvPr/>
        </p:nvPicPr>
        <p:blipFill>
          <a:blip r:embed="rId4"/>
          <a:stretch/>
        </p:blipFill>
        <p:spPr>
          <a:xfrm>
            <a:off x="495360" y="6019920"/>
            <a:ext cx="5753160" cy="1874880"/>
          </a:xfrm>
          <a:prstGeom prst="rect">
            <a:avLst/>
          </a:prstGeom>
          <a:ln w="0">
            <a:noFill/>
          </a:ln>
        </p:spPr>
      </p:pic>
      <p:sp>
        <p:nvSpPr>
          <p:cNvPr id="321" name=""/>
          <p:cNvSpPr/>
          <p:nvPr/>
        </p:nvSpPr>
        <p:spPr>
          <a:xfrm>
            <a:off x="1837080" y="5943600"/>
            <a:ext cx="308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6 – difference NLE22-NLE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2147760" y="7643880"/>
            <a:ext cx="331920" cy="0"/>
          </a:xfrm>
          <a:prstGeom prst="line">
            <a:avLst/>
          </a:prstGeom>
          <a:ln w="381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2489040" y="7643880"/>
            <a:ext cx="658800" cy="0"/>
          </a:xfrm>
          <a:prstGeom prst="line">
            <a:avLst/>
          </a:prstGeom>
          <a:ln w="381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 flipH="1" rot="10800000">
            <a:off x="1497600" y="1760400"/>
            <a:ext cx="75960" cy="169920"/>
          </a:xfrm>
          <a:prstGeom prst="flowChartMerge">
            <a:avLst/>
          </a:prstGeom>
          <a:solidFill>
            <a:srgbClr val="f200a7"/>
          </a:solidFill>
          <a:ln w="93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 flipH="1" rot="10800000">
            <a:off x="1764360" y="3746520"/>
            <a:ext cx="75960" cy="169920"/>
          </a:xfrm>
          <a:prstGeom prst="flowChartMerge">
            <a:avLst/>
          </a:prstGeom>
          <a:solidFill>
            <a:srgbClr val="f200a7"/>
          </a:solidFill>
          <a:ln w="93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 flipH="1" rot="10800000">
            <a:off x="3073320" y="3746520"/>
            <a:ext cx="76320" cy="169920"/>
          </a:xfrm>
          <a:prstGeom prst="flowChartMerge">
            <a:avLst/>
          </a:prstGeom>
          <a:solidFill>
            <a:srgbClr val="f200a7"/>
          </a:solidFill>
          <a:ln w="93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 flipH="1" rot="10800000">
            <a:off x="3376440" y="3746520"/>
            <a:ext cx="76320" cy="169920"/>
          </a:xfrm>
          <a:prstGeom prst="flowChartMerge">
            <a:avLst/>
          </a:prstGeom>
          <a:solidFill>
            <a:srgbClr val="f200a7"/>
          </a:solidFill>
          <a:ln w="93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 flipH="1" rot="10800000">
            <a:off x="1992960" y="5667480"/>
            <a:ext cx="75960" cy="169920"/>
          </a:xfrm>
          <a:prstGeom prst="flowChartMerge">
            <a:avLst/>
          </a:prstGeom>
          <a:solidFill>
            <a:srgbClr val="f200a7"/>
          </a:solidFill>
          <a:ln w="93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 flipH="1" rot="10800000">
            <a:off x="2450160" y="7667640"/>
            <a:ext cx="75960" cy="169920"/>
          </a:xfrm>
          <a:prstGeom prst="flowChartMerge">
            <a:avLst/>
          </a:prstGeom>
          <a:solidFill>
            <a:srgbClr val="f200a7"/>
          </a:solidFill>
          <a:ln w="93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3352680" y="7645320"/>
            <a:ext cx="2743200" cy="0"/>
          </a:xfrm>
          <a:prstGeom prst="line">
            <a:avLst/>
          </a:prstGeom>
          <a:ln w="381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1001160" y="1690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1515960" y="169056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99ff"/>
                </a:solidFill>
                <a:latin typeface="Arial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1458720" y="365616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99ff"/>
                </a:solidFill>
                <a:latin typeface="Arial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1795680" y="36590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1705320" y="5576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2145240" y="7591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cc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2029320" y="55785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cc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2704680" y="36590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66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4420800" y="36590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66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4420800" y="75913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66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2680920" y="75913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66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3081600" y="36576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1775880" y="80233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2077920" y="802152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99ff"/>
                </a:solidFill>
                <a:latin typeface="Arial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2376720" y="80215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2557800" y="8023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cc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2837880" y="80233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66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3923640" y="80215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66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3019680" y="8023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0" name=""/>
          <p:cNvGrpSpPr/>
          <p:nvPr/>
        </p:nvGrpSpPr>
        <p:grpSpPr>
          <a:xfrm>
            <a:off x="1676520" y="8332920"/>
            <a:ext cx="3352320" cy="201600"/>
            <a:chOff x="1676520" y="8332920"/>
            <a:chExt cx="3352320" cy="201600"/>
          </a:xfrm>
        </p:grpSpPr>
        <p:sp>
          <p:nvSpPr>
            <p:cNvPr id="351" name=""/>
            <p:cNvSpPr/>
            <p:nvPr/>
          </p:nvSpPr>
          <p:spPr>
            <a:xfrm rot="16200000">
              <a:off x="2153520" y="7855560"/>
              <a:ext cx="201600" cy="115596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 rot="16200000">
              <a:off x="3867840" y="7373520"/>
              <a:ext cx="201600" cy="212040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 rot="16200000">
              <a:off x="1742400" y="8382600"/>
              <a:ext cx="201600" cy="1018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 rot="16200000">
              <a:off x="1980720" y="8350200"/>
              <a:ext cx="201600" cy="1670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 rot="16200000">
              <a:off x="2361240" y="8397360"/>
              <a:ext cx="201600" cy="723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 rot="16200000">
              <a:off x="2610000" y="8363160"/>
              <a:ext cx="201600" cy="1411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 rot="16200000">
              <a:off x="2878200" y="8363160"/>
              <a:ext cx="201600" cy="1411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 rot="16200000">
              <a:off x="3086280" y="8369640"/>
              <a:ext cx="201600" cy="1281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 rot="16200000">
              <a:off x="3349440" y="8330760"/>
              <a:ext cx="201600" cy="2055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 rot="16200000">
              <a:off x="3858120" y="8240400"/>
              <a:ext cx="201600" cy="3866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 rot="16200000">
              <a:off x="4343040" y="8308800"/>
              <a:ext cx="201600" cy="2494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 rot="16200000">
              <a:off x="4733640" y="8382600"/>
              <a:ext cx="201600" cy="1022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 rot="16200000">
              <a:off x="2804040" y="8397000"/>
              <a:ext cx="144000" cy="7704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0240" bIns="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4" name=""/>
          <p:cNvSpPr/>
          <p:nvPr/>
        </p:nvSpPr>
        <p:spPr>
          <a:xfrm>
            <a:off x="1676520" y="8259840"/>
            <a:ext cx="41112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2092320" y="8259840"/>
            <a:ext cx="344520" cy="0"/>
          </a:xfrm>
          <a:prstGeom prst="line">
            <a:avLst/>
          </a:prstGeom>
          <a:ln w="381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2444760" y="8259840"/>
            <a:ext cx="20484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2657520" y="8259840"/>
            <a:ext cx="141120" cy="0"/>
          </a:xfrm>
          <a:prstGeom prst="line">
            <a:avLst/>
          </a:prstGeom>
          <a:ln w="381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2806560" y="8259840"/>
            <a:ext cx="320760" cy="0"/>
          </a:xfrm>
          <a:prstGeom prst="line">
            <a:avLst/>
          </a:prstGeom>
          <a:ln w="381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3135240" y="8259840"/>
            <a:ext cx="13968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3284640" y="8259840"/>
            <a:ext cx="1733400" cy="0"/>
          </a:xfrm>
          <a:prstGeom prst="line">
            <a:avLst/>
          </a:prstGeom>
          <a:ln w="381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2321280" y="8521560"/>
            <a:ext cx="20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2" name="" descr=""/>
          <p:cNvPicPr/>
          <p:nvPr/>
        </p:nvPicPr>
        <p:blipFill>
          <a:blip r:embed="rId1"/>
          <a:stretch/>
        </p:blipFill>
        <p:spPr>
          <a:xfrm>
            <a:off x="533520" y="50760"/>
            <a:ext cx="5562360" cy="2538360"/>
          </a:xfrm>
          <a:prstGeom prst="rect">
            <a:avLst/>
          </a:prstGeom>
          <a:ln w="0">
            <a:noFill/>
          </a:ln>
        </p:spPr>
      </p:pic>
      <p:pic>
        <p:nvPicPr>
          <p:cNvPr id="373" name="" descr=""/>
          <p:cNvPicPr/>
          <p:nvPr/>
        </p:nvPicPr>
        <p:blipFill>
          <a:blip r:embed="rId2"/>
          <a:stretch/>
        </p:blipFill>
        <p:spPr>
          <a:xfrm>
            <a:off x="660240" y="2666880"/>
            <a:ext cx="5384880" cy="2347920"/>
          </a:xfrm>
          <a:prstGeom prst="rect">
            <a:avLst/>
          </a:prstGeom>
          <a:ln w="0">
            <a:noFill/>
          </a:ln>
        </p:spPr>
      </p:pic>
      <p:sp>
        <p:nvSpPr>
          <p:cNvPr id="374" name=""/>
          <p:cNvSpPr/>
          <p:nvPr/>
        </p:nvSpPr>
        <p:spPr>
          <a:xfrm>
            <a:off x="1754280" y="50760"/>
            <a:ext cx="315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7 – difference NLE11-NLE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1754280" y="2625840"/>
            <a:ext cx="315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7 – difference NLE17-NLE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6" name="" descr=""/>
          <p:cNvPicPr/>
          <p:nvPr/>
        </p:nvPicPr>
        <p:blipFill>
          <a:blip r:embed="rId3"/>
          <a:stretch/>
        </p:blipFill>
        <p:spPr>
          <a:xfrm>
            <a:off x="673200" y="5181480"/>
            <a:ext cx="5333760" cy="2370240"/>
          </a:xfrm>
          <a:prstGeom prst="rect">
            <a:avLst/>
          </a:prstGeom>
          <a:ln w="0">
            <a:noFill/>
          </a:ln>
        </p:spPr>
      </p:pic>
      <p:sp>
        <p:nvSpPr>
          <p:cNvPr id="377" name=""/>
          <p:cNvSpPr/>
          <p:nvPr/>
        </p:nvSpPr>
        <p:spPr>
          <a:xfrm>
            <a:off x="1732320" y="5118120"/>
            <a:ext cx="315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 7 – difference NLE11-NLE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831960" y="2209680"/>
            <a:ext cx="20772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1546200" y="2209680"/>
            <a:ext cx="166680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1060560" y="2206800"/>
            <a:ext cx="46656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3451320" y="2209680"/>
            <a:ext cx="46656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3936960" y="2209680"/>
            <a:ext cx="34308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3733920" y="4724280"/>
            <a:ext cx="34272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4116240" y="4724280"/>
            <a:ext cx="175104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3267000" y="4724280"/>
            <a:ext cx="22860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1639800" y="4724280"/>
            <a:ext cx="160812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3390840" y="7277040"/>
            <a:ext cx="29520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3187800" y="7277040"/>
            <a:ext cx="17460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4114800" y="7257960"/>
            <a:ext cx="182880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 flipH="1" rot="10800000">
            <a:off x="1012680" y="221940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 flipH="1" rot="10800000">
            <a:off x="1508040" y="221940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 flipH="1" rot="10800000">
            <a:off x="3888360" y="2209680"/>
            <a:ext cx="7596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 flipH="1" rot="10800000">
            <a:off x="3219480" y="472428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 flipH="1" rot="10800000">
            <a:off x="4057560" y="472428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 flipH="1" rot="10800000">
            <a:off x="3343320" y="727704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736920" y="2184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2070360" y="2184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3915000" y="2184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1070280" y="2184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3480120" y="2184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3368880" y="72388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2397600" y="4703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3711960" y="4703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3226320" y="46944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0bb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4753440" y="47242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0bb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3073680" y="72388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0bb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4762800" y="72565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0bb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1665720" y="78408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2411640" y="78408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3376800" y="784080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2d8f4b"/>
                </a:solidFill>
                <a:latin typeface="Arial"/>
              </a:rPr>
              <a:t>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1872000" y="7834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2" name=""/>
          <p:cNvGrpSpPr/>
          <p:nvPr/>
        </p:nvGrpSpPr>
        <p:grpSpPr>
          <a:xfrm>
            <a:off x="1763640" y="8167680"/>
            <a:ext cx="3255840" cy="201240"/>
            <a:chOff x="1763640" y="8167680"/>
            <a:chExt cx="3255840" cy="201240"/>
          </a:xfrm>
        </p:grpSpPr>
        <p:sp>
          <p:nvSpPr>
            <p:cNvPr id="413" name=""/>
            <p:cNvSpPr/>
            <p:nvPr/>
          </p:nvSpPr>
          <p:spPr>
            <a:xfrm rot="16200000">
              <a:off x="2173680" y="7757640"/>
              <a:ext cx="200160" cy="102024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 rot="16200000">
              <a:off x="3851280" y="7199280"/>
              <a:ext cx="197280" cy="213876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 rot="16200000">
              <a:off x="1955880" y="8144280"/>
              <a:ext cx="197280" cy="2487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 rot="16200000">
              <a:off x="2338560" y="8192880"/>
              <a:ext cx="197280" cy="1515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 rot="16200000">
              <a:off x="2557800" y="8214120"/>
              <a:ext cx="197280" cy="1094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 rot="16200000">
              <a:off x="3301920" y="8061480"/>
              <a:ext cx="197280" cy="4147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 rot="16200000">
              <a:off x="3979080" y="8061480"/>
              <a:ext cx="197280" cy="41436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 rot="16200000">
              <a:off x="4475160" y="8214120"/>
              <a:ext cx="198720" cy="1108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 rot="16200000">
              <a:off x="4666680" y="8214480"/>
              <a:ext cx="198720" cy="10980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 rot="16200000">
              <a:off x="2762640" y="8227800"/>
              <a:ext cx="143280" cy="8460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7800" bIns="37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23" name=""/>
          <p:cNvSpPr/>
          <p:nvPr/>
        </p:nvSpPr>
        <p:spPr>
          <a:xfrm>
            <a:off x="1754280" y="8078760"/>
            <a:ext cx="16488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1930320" y="8078760"/>
            <a:ext cx="26208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2201760" y="8078760"/>
            <a:ext cx="85572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3070080" y="8078760"/>
            <a:ext cx="13968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3224160" y="8078760"/>
            <a:ext cx="235080" cy="0"/>
          </a:xfrm>
          <a:prstGeom prst="line">
            <a:avLst/>
          </a:prstGeom>
          <a:ln w="3816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3471840" y="8078760"/>
            <a:ext cx="163440" cy="0"/>
          </a:xfrm>
          <a:prstGeom prst="line">
            <a:avLst/>
          </a:prstGeom>
          <a:ln w="38160">
            <a:solidFill>
              <a:srgbClr val="2d8f4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3651120" y="8078760"/>
            <a:ext cx="1378080" cy="0"/>
          </a:xfrm>
          <a:prstGeom prst="line">
            <a:avLst/>
          </a:prstGeom>
          <a:ln w="38160">
            <a:solidFill>
              <a:srgbClr val="f4ee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3157920" y="7835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33"/>
                </a:solidFill>
                <a:latin typeface="Arial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2945160" y="78343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0bb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4043880" y="78357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0bb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2321280" y="8331120"/>
            <a:ext cx="20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4" name="" descr=""/>
          <p:cNvPicPr/>
          <p:nvPr/>
        </p:nvPicPr>
        <p:blipFill>
          <a:blip r:embed="rId1"/>
          <a:stretch/>
        </p:blipFill>
        <p:spPr>
          <a:xfrm>
            <a:off x="457200" y="88920"/>
            <a:ext cx="6140520" cy="3203640"/>
          </a:xfrm>
          <a:prstGeom prst="rect">
            <a:avLst/>
          </a:prstGeom>
          <a:ln w="0">
            <a:noFill/>
          </a:ln>
        </p:spPr>
      </p:pic>
      <p:pic>
        <p:nvPicPr>
          <p:cNvPr id="435" name="" descr=""/>
          <p:cNvPicPr/>
          <p:nvPr/>
        </p:nvPicPr>
        <p:blipFill>
          <a:blip r:embed="rId2"/>
          <a:stretch/>
        </p:blipFill>
        <p:spPr>
          <a:xfrm>
            <a:off x="533520" y="3249720"/>
            <a:ext cx="5981760" cy="3379680"/>
          </a:xfrm>
          <a:prstGeom prst="rect">
            <a:avLst/>
          </a:prstGeom>
          <a:ln w="0">
            <a:noFill/>
          </a:ln>
        </p:spPr>
      </p:pic>
      <p:sp>
        <p:nvSpPr>
          <p:cNvPr id="436" name=""/>
          <p:cNvSpPr/>
          <p:nvPr/>
        </p:nvSpPr>
        <p:spPr>
          <a:xfrm>
            <a:off x="2046600" y="114480"/>
            <a:ext cx="298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8 – difference NLE4-NLE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1983240" y="3252960"/>
            <a:ext cx="3050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8 – difference NLE8-NLE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762120" y="2743200"/>
            <a:ext cx="785520" cy="0"/>
          </a:xfrm>
          <a:prstGeom prst="line">
            <a:avLst/>
          </a:prstGeom>
          <a:ln w="38160">
            <a:solidFill>
              <a:srgbClr val="f200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1557360" y="2743200"/>
            <a:ext cx="112392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1533600" y="6019920"/>
            <a:ext cx="112392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2666880" y="6019920"/>
            <a:ext cx="3657600" cy="0"/>
          </a:xfrm>
          <a:prstGeom prst="line">
            <a:avLst/>
          </a:prstGeom>
          <a:ln w="381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 flipH="1" rot="10800000">
            <a:off x="1514520" y="277164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 flipH="1" rot="10800000">
            <a:off x="2624040" y="604368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1032840" y="2690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200a7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2042640" y="2690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1944360" y="59641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3457800" y="59626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ff00"/>
                </a:solidFill>
                <a:latin typeface="Arial"/>
              </a:rPr>
              <a:t>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8" name=""/>
          <p:cNvGrpSpPr/>
          <p:nvPr/>
        </p:nvGrpSpPr>
        <p:grpSpPr>
          <a:xfrm>
            <a:off x="1905120" y="6781680"/>
            <a:ext cx="3201840" cy="545760"/>
            <a:chOff x="1905120" y="6781680"/>
            <a:chExt cx="3201840" cy="545760"/>
          </a:xfrm>
        </p:grpSpPr>
        <p:grpSp>
          <p:nvGrpSpPr>
            <p:cNvPr id="449" name=""/>
            <p:cNvGrpSpPr/>
            <p:nvPr/>
          </p:nvGrpSpPr>
          <p:grpSpPr>
            <a:xfrm>
              <a:off x="1905120" y="7035840"/>
              <a:ext cx="3201840" cy="291600"/>
              <a:chOff x="1905120" y="7035840"/>
              <a:chExt cx="3201840" cy="291600"/>
            </a:xfrm>
          </p:grpSpPr>
          <p:sp>
            <p:nvSpPr>
              <p:cNvPr id="450" name=""/>
              <p:cNvSpPr/>
              <p:nvPr/>
            </p:nvSpPr>
            <p:spPr>
              <a:xfrm rot="16200000">
                <a:off x="2243880" y="6786000"/>
                <a:ext cx="202680" cy="880200"/>
              </a:xfrm>
              <a:prstGeom prst="rect">
                <a:avLst/>
              </a:prstGeom>
              <a:gradFill rotWithShape="0">
                <a:gsLst>
                  <a:gs pos="0">
                    <a:srgbClr val="d9e7fb"/>
                  </a:gs>
                  <a:gs pos="50000">
                    <a:srgbClr val="ffffff"/>
                  </a:gs>
                  <a:gs pos="100000">
                    <a:srgbClr val="d9e7fb"/>
                  </a:gs>
                </a:gsLst>
                <a:lin ang="16200000"/>
              </a:gradFill>
              <a:ln w="9360">
                <a:solidFill>
                  <a:srgbClr val="71bfc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"/>
              <p:cNvSpPr/>
              <p:nvPr/>
            </p:nvSpPr>
            <p:spPr>
              <a:xfrm rot="16200000">
                <a:off x="3889800" y="6123960"/>
                <a:ext cx="202680" cy="2204280"/>
              </a:xfrm>
              <a:prstGeom prst="rect">
                <a:avLst/>
              </a:prstGeom>
              <a:gradFill rotWithShape="0">
                <a:gsLst>
                  <a:gs pos="0">
                    <a:srgbClr val="d9e7fb"/>
                  </a:gs>
                  <a:gs pos="50000">
                    <a:srgbClr val="ffffff"/>
                  </a:gs>
                  <a:gs pos="100000">
                    <a:srgbClr val="d9e7fb"/>
                  </a:gs>
                </a:gsLst>
                <a:lin ang="16200000"/>
              </a:gradFill>
              <a:ln w="9360">
                <a:solidFill>
                  <a:srgbClr val="71bfc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"/>
              <p:cNvSpPr/>
              <p:nvPr/>
            </p:nvSpPr>
            <p:spPr>
              <a:xfrm rot="16200000">
                <a:off x="2103120" y="7130520"/>
                <a:ext cx="202680" cy="19116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"/>
              <p:cNvSpPr/>
              <p:nvPr/>
            </p:nvSpPr>
            <p:spPr>
              <a:xfrm rot="16200000">
                <a:off x="2462400" y="7130520"/>
                <a:ext cx="202680" cy="19116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"/>
              <p:cNvSpPr/>
              <p:nvPr/>
            </p:nvSpPr>
            <p:spPr>
              <a:xfrm rot="16200000">
                <a:off x="2949480" y="7146000"/>
                <a:ext cx="202680" cy="16020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"/>
              <p:cNvSpPr/>
              <p:nvPr/>
            </p:nvSpPr>
            <p:spPr>
              <a:xfrm rot="16200000">
                <a:off x="3433680" y="7101360"/>
                <a:ext cx="202680" cy="24948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"/>
              <p:cNvSpPr/>
              <p:nvPr/>
            </p:nvSpPr>
            <p:spPr>
              <a:xfrm rot="16200000">
                <a:off x="3760560" y="7079400"/>
                <a:ext cx="202680" cy="29340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"/>
              <p:cNvSpPr/>
              <p:nvPr/>
            </p:nvSpPr>
            <p:spPr>
              <a:xfrm rot="16200000">
                <a:off x="4372200" y="7101360"/>
                <a:ext cx="202680" cy="24948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"/>
              <p:cNvSpPr/>
              <p:nvPr/>
            </p:nvSpPr>
            <p:spPr>
              <a:xfrm rot="16200000">
                <a:off x="4817880" y="7185240"/>
                <a:ext cx="202680" cy="8136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4560" bIns="34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"/>
              <p:cNvSpPr/>
              <p:nvPr/>
            </p:nvSpPr>
            <p:spPr>
              <a:xfrm rot="16200000">
                <a:off x="2763360" y="7184160"/>
                <a:ext cx="147240" cy="88560"/>
              </a:xfrm>
              <a:prstGeom prst="rect">
                <a:avLst/>
              </a:prstGeom>
              <a:blipFill rotWithShape="0">
                <a:blip r:embed="rId3"/>
                <a:srcRect/>
                <a:tile tx="0" ty="0" sx="100000" sy="100000" algn="ctr"/>
              </a:blip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1760" bIns="41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"/>
              <p:cNvSpPr/>
              <p:nvPr/>
            </p:nvSpPr>
            <p:spPr>
              <a:xfrm>
                <a:off x="1906200" y="7035840"/>
                <a:ext cx="483840" cy="0"/>
              </a:xfrm>
              <a:prstGeom prst="line">
                <a:avLst/>
              </a:prstGeom>
              <a:ln w="38160">
                <a:solidFill>
                  <a:srgbClr val="f200a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"/>
              <p:cNvSpPr/>
              <p:nvPr/>
            </p:nvSpPr>
            <p:spPr>
              <a:xfrm>
                <a:off x="2401560" y="7035840"/>
                <a:ext cx="498600" cy="0"/>
              </a:xfrm>
              <a:prstGeom prst="line">
                <a:avLst/>
              </a:prstGeom>
              <a:ln w="38160">
                <a:solidFill>
                  <a:srgbClr val="57d2e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"/>
              <p:cNvSpPr/>
              <p:nvPr/>
            </p:nvSpPr>
            <p:spPr>
              <a:xfrm>
                <a:off x="2933640" y="7035840"/>
                <a:ext cx="2173320" cy="0"/>
              </a:xfrm>
              <a:prstGeom prst="line">
                <a:avLst/>
              </a:prstGeom>
              <a:ln w="3816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3" name=""/>
            <p:cNvSpPr/>
            <p:nvPr/>
          </p:nvSpPr>
          <p:spPr>
            <a:xfrm>
              <a:off x="2032920" y="679464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200a7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2476080" y="678168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57d2ef"/>
                  </a:solidFill>
                  <a:latin typeface="Arial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3686400" y="678348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ff00"/>
                  </a:solidFill>
                  <a:latin typeface="Arial"/>
                </a:rPr>
                <a:t>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6" name=""/>
          <p:cNvSpPr/>
          <p:nvPr/>
        </p:nvSpPr>
        <p:spPr>
          <a:xfrm>
            <a:off x="2473920" y="7289640"/>
            <a:ext cx="20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7" name="" descr=""/>
          <p:cNvPicPr/>
          <p:nvPr/>
        </p:nvPicPr>
        <p:blipFill>
          <a:blip r:embed="rId1"/>
          <a:stretch/>
        </p:blipFill>
        <p:spPr>
          <a:xfrm>
            <a:off x="368280" y="88920"/>
            <a:ext cx="6095880" cy="2590920"/>
          </a:xfrm>
          <a:prstGeom prst="rect">
            <a:avLst/>
          </a:prstGeom>
          <a:ln w="0">
            <a:noFill/>
          </a:ln>
        </p:spPr>
      </p:pic>
      <p:sp>
        <p:nvSpPr>
          <p:cNvPr id="468" name=""/>
          <p:cNvSpPr/>
          <p:nvPr/>
        </p:nvSpPr>
        <p:spPr>
          <a:xfrm>
            <a:off x="1894320" y="98280"/>
            <a:ext cx="3058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9 – difference NLE1b-NLE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557280" y="2309760"/>
            <a:ext cx="904680" cy="0"/>
          </a:xfrm>
          <a:prstGeom prst="line">
            <a:avLst/>
          </a:prstGeom>
          <a:ln w="381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1690560" y="2309760"/>
            <a:ext cx="155880" cy="0"/>
          </a:xfrm>
          <a:prstGeom prst="line">
            <a:avLst/>
          </a:prstGeom>
          <a:ln w="381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3375000" y="2309760"/>
            <a:ext cx="1763640" cy="0"/>
          </a:xfrm>
          <a:prstGeom prst="line">
            <a:avLst/>
          </a:prstGeom>
          <a:ln w="381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1471680" y="2309760"/>
            <a:ext cx="20952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1859040" y="2308320"/>
            <a:ext cx="49824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5153040" y="2308320"/>
            <a:ext cx="1095480" cy="0"/>
          </a:xfrm>
          <a:prstGeom prst="line">
            <a:avLst/>
          </a:prstGeom>
          <a:ln w="38160">
            <a:solidFill>
              <a:srgbClr val="57d2e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2143080" y="1028880"/>
            <a:ext cx="295200" cy="75960"/>
          </a:xfrm>
          <a:prstGeom prst="rect">
            <a:avLst/>
          </a:prstGeom>
          <a:solidFill>
            <a:srgbClr val="35f735"/>
          </a:solidFill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4610160" y="457200"/>
            <a:ext cx="152280" cy="76320"/>
          </a:xfrm>
          <a:prstGeom prst="rect">
            <a:avLst/>
          </a:prstGeom>
          <a:solidFill>
            <a:srgbClr val="35f735"/>
          </a:solidFill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4714560" y="365040"/>
            <a:ext cx="153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egmental duplic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3181320" y="1028880"/>
            <a:ext cx="152280" cy="75960"/>
          </a:xfrm>
          <a:prstGeom prst="rect">
            <a:avLst/>
          </a:prstGeom>
          <a:solidFill>
            <a:srgbClr val="35f735"/>
          </a:solidFill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747720" y="22636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99ff"/>
                </a:solidFill>
                <a:latin typeface="Arial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1573200" y="20764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99ff"/>
                </a:solidFill>
                <a:latin typeface="Arial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4116240" y="226836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cc99ff"/>
                </a:solidFill>
                <a:latin typeface="Arial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1439280" y="2268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1999800" y="2268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5716080" y="2268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57d2ef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5" name="" descr=""/>
          <p:cNvPicPr/>
          <p:nvPr/>
        </p:nvPicPr>
        <p:blipFill>
          <a:blip r:embed="rId2"/>
          <a:stretch/>
        </p:blipFill>
        <p:spPr>
          <a:xfrm>
            <a:off x="304920" y="3606840"/>
            <a:ext cx="6095880" cy="2081160"/>
          </a:xfrm>
          <a:prstGeom prst="rect">
            <a:avLst/>
          </a:prstGeom>
          <a:ln w="0">
            <a:noFill/>
          </a:ln>
        </p:spPr>
      </p:pic>
      <p:pic>
        <p:nvPicPr>
          <p:cNvPr id="486" name="" descr=""/>
          <p:cNvPicPr/>
          <p:nvPr/>
        </p:nvPicPr>
        <p:blipFill>
          <a:blip r:embed="rId3"/>
          <a:stretch/>
        </p:blipFill>
        <p:spPr>
          <a:xfrm>
            <a:off x="380880" y="5892840"/>
            <a:ext cx="5943600" cy="2209680"/>
          </a:xfrm>
          <a:prstGeom prst="rect">
            <a:avLst/>
          </a:prstGeom>
          <a:ln w="0">
            <a:noFill/>
          </a:ln>
        </p:spPr>
      </p:pic>
      <p:sp>
        <p:nvSpPr>
          <p:cNvPr id="487" name=""/>
          <p:cNvSpPr/>
          <p:nvPr/>
        </p:nvSpPr>
        <p:spPr>
          <a:xfrm>
            <a:off x="654120" y="5359320"/>
            <a:ext cx="977760" cy="0"/>
          </a:xfrm>
          <a:prstGeom prst="line">
            <a:avLst/>
          </a:prstGeom>
          <a:ln w="381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1643040" y="5356080"/>
            <a:ext cx="116064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3124080" y="5354640"/>
            <a:ext cx="121932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1600200" y="7721640"/>
            <a:ext cx="120024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3060720" y="7721640"/>
            <a:ext cx="1306440" cy="0"/>
          </a:xfrm>
          <a:prstGeom prst="line">
            <a:avLst/>
          </a:prstGeom>
          <a:ln w="38160">
            <a:solidFill>
              <a:srgbClr val="ff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2806560" y="7721640"/>
            <a:ext cx="246240" cy="0"/>
          </a:xfrm>
          <a:prstGeom prst="line">
            <a:avLst/>
          </a:prstGeom>
          <a:ln w="381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4376880" y="7721640"/>
            <a:ext cx="1876320" cy="0"/>
          </a:xfrm>
          <a:prstGeom prst="line">
            <a:avLst/>
          </a:prstGeom>
          <a:ln w="381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915480" y="5313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cc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2010240" y="53132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3457800" y="53132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3534120" y="76611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2067120" y="765972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9999"/>
                </a:solidFill>
                <a:latin typeface="Arial"/>
              </a:rPr>
              <a:t>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2799720" y="76662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66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5142960" y="76662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66ff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1767240" y="3467160"/>
            <a:ext cx="312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0 – difference NLE9-NLE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1818000" y="5740560"/>
            <a:ext cx="312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uman chromosome10 – difference NLE18-NLE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 flipH="1" rot="10800000">
            <a:off x="1427040" y="233352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 flipH="1" rot="10800000">
            <a:off x="1647720" y="233352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 flipH="1" rot="10800000">
            <a:off x="1814400" y="2333520"/>
            <a:ext cx="76320" cy="169920"/>
          </a:xfrm>
          <a:prstGeom prst="flowChartMerge">
            <a:avLst/>
          </a:prstGeom>
          <a:solidFill>
            <a:srgbClr val="808080"/>
          </a:solidFill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 flipH="1" rot="10800000">
            <a:off x="5110200" y="232884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 flipH="1" rot="10800000">
            <a:off x="1602360" y="5379840"/>
            <a:ext cx="75960" cy="16956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 flipH="1" rot="10800000">
            <a:off x="2763720" y="775008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 flipH="1" rot="10800000">
            <a:off x="3019320" y="775008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 flipH="1" rot="10800000">
            <a:off x="4335480" y="7750080"/>
            <a:ext cx="76320" cy="169920"/>
          </a:xfrm>
          <a:prstGeom prst="flowChartMerge">
            <a:avLst/>
          </a:prstGeom>
          <a:solidFill>
            <a:srgbClr val="009999"/>
          </a:solidFill>
          <a:ln w="9360">
            <a:solidFill>
              <a:srgbClr val="00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160" bIns="38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1" name=""/>
          <p:cNvGrpSpPr/>
          <p:nvPr/>
        </p:nvGrpSpPr>
        <p:grpSpPr>
          <a:xfrm>
            <a:off x="1905120" y="2584440"/>
            <a:ext cx="3047400" cy="506160"/>
            <a:chOff x="1905120" y="2584440"/>
            <a:chExt cx="3047400" cy="506160"/>
          </a:xfrm>
        </p:grpSpPr>
        <p:grpSp>
          <p:nvGrpSpPr>
            <p:cNvPr id="512" name=""/>
            <p:cNvGrpSpPr/>
            <p:nvPr/>
          </p:nvGrpSpPr>
          <p:grpSpPr>
            <a:xfrm>
              <a:off x="1905120" y="2793960"/>
              <a:ext cx="3047400" cy="296640"/>
              <a:chOff x="1905120" y="2793960"/>
              <a:chExt cx="3047400" cy="296640"/>
            </a:xfrm>
          </p:grpSpPr>
          <p:sp>
            <p:nvSpPr>
              <p:cNvPr id="513" name=""/>
              <p:cNvSpPr/>
              <p:nvPr/>
            </p:nvSpPr>
            <p:spPr>
              <a:xfrm rot="16200000">
                <a:off x="2236680" y="2543040"/>
                <a:ext cx="225360" cy="863280"/>
              </a:xfrm>
              <a:prstGeom prst="rect">
                <a:avLst/>
              </a:prstGeom>
              <a:gradFill rotWithShape="0">
                <a:gsLst>
                  <a:gs pos="0">
                    <a:srgbClr val="d9e7fb"/>
                  </a:gs>
                  <a:gs pos="50000">
                    <a:srgbClr val="ffffff"/>
                  </a:gs>
                  <a:gs pos="100000">
                    <a:srgbClr val="d9e7fb"/>
                  </a:gs>
                </a:gsLst>
                <a:lin ang="16200000"/>
              </a:gradFill>
              <a:ln w="9360">
                <a:solidFill>
                  <a:srgbClr val="71bfc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"/>
              <p:cNvSpPr/>
              <p:nvPr/>
            </p:nvSpPr>
            <p:spPr>
              <a:xfrm rot="16200000">
                <a:off x="3804840" y="1953000"/>
                <a:ext cx="225360" cy="2049840"/>
              </a:xfrm>
              <a:prstGeom prst="rect">
                <a:avLst/>
              </a:prstGeom>
              <a:gradFill rotWithShape="0">
                <a:gsLst>
                  <a:gs pos="0">
                    <a:srgbClr val="d9e7fb"/>
                  </a:gs>
                  <a:gs pos="50000">
                    <a:srgbClr val="ffffff"/>
                  </a:gs>
                  <a:gs pos="100000">
                    <a:srgbClr val="d9e7fb"/>
                  </a:gs>
                </a:gsLst>
                <a:lin ang="16200000"/>
              </a:gradFill>
              <a:ln w="9360">
                <a:solidFill>
                  <a:srgbClr val="71bfc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"/>
              <p:cNvSpPr/>
              <p:nvPr/>
            </p:nvSpPr>
            <p:spPr>
              <a:xfrm rot="16200000">
                <a:off x="2018520" y="2881080"/>
                <a:ext cx="225360" cy="18720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"/>
              <p:cNvSpPr/>
              <p:nvPr/>
            </p:nvSpPr>
            <p:spPr>
              <a:xfrm rot="16200000">
                <a:off x="2288520" y="2838960"/>
                <a:ext cx="227160" cy="27216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"/>
              <p:cNvSpPr/>
              <p:nvPr/>
            </p:nvSpPr>
            <p:spPr>
              <a:xfrm rot="16200000">
                <a:off x="2619720" y="2920680"/>
                <a:ext cx="225360" cy="11412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"/>
              <p:cNvSpPr/>
              <p:nvPr/>
            </p:nvSpPr>
            <p:spPr>
              <a:xfrm flipV="1" rot="16200000">
                <a:off x="2959920" y="2797200"/>
                <a:ext cx="225360" cy="361080"/>
              </a:xfrm>
              <a:prstGeom prst="rect">
                <a:avLst/>
              </a:prstGeom>
              <a:gradFill rotWithShape="0">
                <a:gsLst>
                  <a:gs pos="0">
                    <a:srgbClr val="000000"/>
                  </a:gs>
                  <a:gs pos="50000">
                    <a:srgbClr val="b2b2b2"/>
                  </a:gs>
                  <a:gs pos="100000">
                    <a:srgbClr val="000000"/>
                  </a:gs>
                </a:gsLst>
                <a:lin ang="5400000"/>
              </a:gra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"/>
              <p:cNvSpPr/>
              <p:nvPr/>
            </p:nvSpPr>
            <p:spPr>
              <a:xfrm rot="16200000">
                <a:off x="3431880" y="2747880"/>
                <a:ext cx="225360" cy="46008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"/>
              <p:cNvSpPr/>
              <p:nvPr/>
            </p:nvSpPr>
            <p:spPr>
              <a:xfrm rot="16200000">
                <a:off x="4281120" y="2883240"/>
                <a:ext cx="223920" cy="18756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"/>
              <p:cNvSpPr/>
              <p:nvPr/>
            </p:nvSpPr>
            <p:spPr>
              <a:xfrm rot="16200000">
                <a:off x="4715640" y="2936880"/>
                <a:ext cx="223920" cy="80280"/>
              </a:xfrm>
              <a:prstGeom prst="rect">
                <a:avLst/>
              </a:prstGeom>
              <a:gradFill rotWithShape="0">
                <a:gsLst>
                  <a:gs pos="0">
                    <a:srgbClr val="666699"/>
                  </a:gs>
                  <a:gs pos="50000">
                    <a:srgbClr val="e5f4ff"/>
                  </a:gs>
                  <a:gs pos="100000">
                    <a:srgbClr val="666699"/>
                  </a:gs>
                </a:gsLst>
                <a:lin ang="16200000"/>
              </a:grad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3480" bIns="33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"/>
              <p:cNvSpPr/>
              <p:nvPr/>
            </p:nvSpPr>
            <p:spPr>
              <a:xfrm rot="16200000">
                <a:off x="2756520" y="2937600"/>
                <a:ext cx="164880" cy="87120"/>
              </a:xfrm>
              <a:prstGeom prst="rect">
                <a:avLst/>
              </a:prstGeom>
              <a:blipFill rotWithShape="0">
                <a:blip r:embed="rId4"/>
                <a:srcRect/>
                <a:tile tx="0" ty="0" sx="100000" sy="100000" algn="ctr"/>
              </a:blipFill>
              <a:ln w="9360">
                <a:solidFill>
                  <a:srgbClr val="6666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0320" bIns="403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"/>
              <p:cNvSpPr/>
              <p:nvPr/>
            </p:nvSpPr>
            <p:spPr>
              <a:xfrm>
                <a:off x="1905120" y="2793960"/>
                <a:ext cx="361080" cy="0"/>
              </a:xfrm>
              <a:prstGeom prst="line">
                <a:avLst/>
              </a:prstGeom>
              <a:ln w="3816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"/>
              <p:cNvSpPr/>
              <p:nvPr/>
            </p:nvSpPr>
            <p:spPr>
              <a:xfrm>
                <a:off x="2276280" y="2793960"/>
                <a:ext cx="129240" cy="0"/>
              </a:xfrm>
              <a:prstGeom prst="line">
                <a:avLst/>
              </a:prstGeom>
              <a:ln w="38160">
                <a:solidFill>
                  <a:srgbClr val="57d2e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"/>
              <p:cNvSpPr/>
              <p:nvPr/>
            </p:nvSpPr>
            <p:spPr>
              <a:xfrm>
                <a:off x="2418480" y="2793960"/>
                <a:ext cx="115560" cy="0"/>
              </a:xfrm>
              <a:prstGeom prst="line">
                <a:avLst/>
              </a:prstGeom>
              <a:ln w="3816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"/>
              <p:cNvSpPr/>
              <p:nvPr/>
            </p:nvSpPr>
            <p:spPr>
              <a:xfrm>
                <a:off x="2553840" y="2793960"/>
                <a:ext cx="302040" cy="0"/>
              </a:xfrm>
              <a:prstGeom prst="line">
                <a:avLst/>
              </a:prstGeom>
              <a:ln w="38160">
                <a:solidFill>
                  <a:srgbClr val="57d2e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"/>
              <p:cNvSpPr/>
              <p:nvPr/>
            </p:nvSpPr>
            <p:spPr>
              <a:xfrm>
                <a:off x="3251160" y="2793960"/>
                <a:ext cx="1238760" cy="0"/>
              </a:xfrm>
              <a:prstGeom prst="line">
                <a:avLst/>
              </a:prstGeom>
              <a:ln w="3816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"/>
              <p:cNvSpPr/>
              <p:nvPr/>
            </p:nvSpPr>
            <p:spPr>
              <a:xfrm>
                <a:off x="4503960" y="2793960"/>
                <a:ext cx="448560" cy="0"/>
              </a:xfrm>
              <a:prstGeom prst="line">
                <a:avLst/>
              </a:prstGeom>
              <a:ln w="38160">
                <a:solidFill>
                  <a:srgbClr val="57d2e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29" name=""/>
            <p:cNvSpPr/>
            <p:nvPr/>
          </p:nvSpPr>
          <p:spPr>
            <a:xfrm>
              <a:off x="1915920" y="258624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cc99ff"/>
                  </a:solidFill>
                  <a:latin typeface="Arial"/>
                </a:rPr>
                <a:t>1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2292120" y="258444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cc99ff"/>
                  </a:solidFill>
                  <a:latin typeface="Arial"/>
                </a:rPr>
                <a:t>1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3744720" y="258444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cc99ff"/>
                  </a:solidFill>
                  <a:latin typeface="Arial"/>
                </a:rPr>
                <a:t>1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2199960" y="25909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57d2ef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2552400" y="25891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57d2ef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4573440" y="25891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57d2ef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5" name=""/>
          <p:cNvGrpSpPr/>
          <p:nvPr/>
        </p:nvGrpSpPr>
        <p:grpSpPr>
          <a:xfrm>
            <a:off x="1847880" y="8115480"/>
            <a:ext cx="2978280" cy="536400"/>
            <a:chOff x="1847880" y="8115480"/>
            <a:chExt cx="2978280" cy="536400"/>
          </a:xfrm>
        </p:grpSpPr>
        <p:sp>
          <p:nvSpPr>
            <p:cNvPr id="536" name=""/>
            <p:cNvSpPr/>
            <p:nvPr/>
          </p:nvSpPr>
          <p:spPr>
            <a:xfrm rot="16200000">
              <a:off x="2143800" y="8142480"/>
              <a:ext cx="214200" cy="79704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 rot="16200000">
              <a:off x="3678120" y="7513560"/>
              <a:ext cx="214560" cy="2059200"/>
            </a:xfrm>
            <a:prstGeom prst="rect">
              <a:avLst/>
            </a:prstGeom>
            <a:gradFill rotWithShape="0">
              <a:gsLst>
                <a:gs pos="0">
                  <a:srgbClr val="d9e7fb"/>
                </a:gs>
                <a:gs pos="50000">
                  <a:srgbClr val="ffffff"/>
                </a:gs>
                <a:gs pos="100000">
                  <a:srgbClr val="d9e7fb"/>
                </a:gs>
              </a:gsLst>
              <a:lin ang="16200000"/>
            </a:gradFill>
            <a:ln w="9360">
              <a:solidFill>
                <a:srgbClr val="71bfc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 rot="16200000">
              <a:off x="1946160" y="8483040"/>
              <a:ext cx="214200" cy="11592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 rot="16200000">
              <a:off x="2223000" y="8449200"/>
              <a:ext cx="216000" cy="18900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 rot="16200000">
              <a:off x="3088440" y="8325720"/>
              <a:ext cx="214560" cy="43488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 rot="16200000">
              <a:off x="3844800" y="8434440"/>
              <a:ext cx="214560" cy="2174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 rot="16200000">
              <a:off x="4275720" y="8427240"/>
              <a:ext cx="214560" cy="231840"/>
            </a:xfrm>
            <a:prstGeom prst="rect">
              <a:avLst/>
            </a:prstGeom>
            <a:gradFill rotWithShape="0">
              <a:gsLst>
                <a:gs pos="0">
                  <a:srgbClr val="666699"/>
                </a:gs>
                <a:gs pos="50000">
                  <a:srgbClr val="e5f4ff"/>
                </a:gs>
                <a:gs pos="100000">
                  <a:srgbClr val="666699"/>
                </a:gs>
              </a:gsLst>
              <a:lin ang="16200000"/>
            </a:grad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 rot="16200000">
              <a:off x="2627280" y="8502480"/>
              <a:ext cx="155520" cy="8892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6666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1847880" y="8345520"/>
              <a:ext cx="479520" cy="0"/>
            </a:xfrm>
            <a:prstGeom prst="line">
              <a:avLst/>
            </a:prstGeom>
            <a:ln w="381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2346480" y="8345520"/>
              <a:ext cx="566640" cy="0"/>
            </a:xfrm>
            <a:prstGeom prst="line">
              <a:avLst/>
            </a:prstGeom>
            <a:ln w="38160">
              <a:solidFill>
                <a:srgbClr val="ff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2921040" y="8345520"/>
              <a:ext cx="203040" cy="0"/>
            </a:xfrm>
            <a:prstGeom prst="line">
              <a:avLst/>
            </a:prstGeom>
            <a:ln w="381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3130560" y="8345520"/>
              <a:ext cx="857160" cy="0"/>
            </a:xfrm>
            <a:prstGeom prst="line">
              <a:avLst/>
            </a:prstGeom>
            <a:ln w="38160">
              <a:solidFill>
                <a:srgbClr val="ff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4000680" y="8345520"/>
              <a:ext cx="825480" cy="0"/>
            </a:xfrm>
            <a:prstGeom prst="line">
              <a:avLst/>
            </a:prstGeom>
            <a:ln w="381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1963080" y="811692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cc00"/>
                  </a:solidFill>
                  <a:latin typeface="Arial"/>
                </a:rPr>
                <a:t>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2438640" y="811548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9999"/>
                  </a:solidFill>
                  <a:latin typeface="Arial"/>
                </a:rPr>
                <a:t>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3368880" y="811548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9999"/>
                  </a:solidFill>
                  <a:latin typeface="Arial"/>
                </a:rPr>
                <a:t>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2876040" y="81216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66ff"/>
                  </a:solidFill>
                  <a:latin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4247640" y="81234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66ff"/>
                  </a:solidFill>
                  <a:latin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4" name=""/>
          <p:cNvSpPr/>
          <p:nvPr/>
        </p:nvSpPr>
        <p:spPr>
          <a:xfrm>
            <a:off x="2222640" y="8631360"/>
            <a:ext cx="21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2321280" y="3062160"/>
            <a:ext cx="20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uman chromosome 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6-28T01:37:00Z</dcterms:created>
  <dc:creator>Bacpacguest</dc:creator>
  <dc:description/>
  <dc:language>en-US</dc:language>
  <cp:lastModifiedBy>Bacpacguest</cp:lastModifiedBy>
  <dcterms:modified xsi:type="dcterms:W3CDTF">2006-10-12T00:03:49Z</dcterms:modified>
  <cp:revision>155</cp:revision>
  <dc:subject/>
  <dc:title>Slide 1</dc:title>
</cp:coreProperties>
</file>